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93" d="100"/>
          <a:sy n="93" d="100"/>
        </p:scale>
        <p:origin x="7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BDBE6A1-D088-4F00-BCE9-86AA6D260958}" type="doc">
      <dgm:prSet loTypeId="urn:microsoft.com/office/officeart/2005/8/layout/radial4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6367C59A-8C5B-4270-B7C1-0DA7F52229F7}">
      <dgm:prSet phldrT="[Text]" custT="1"/>
      <dgm:spPr/>
      <dgm:t>
        <a:bodyPr/>
        <a:lstStyle/>
        <a:p>
          <a:r>
            <a:rPr lang="de-DE" sz="3600" dirty="0"/>
            <a:t>EAT </a:t>
          </a:r>
          <a:r>
            <a:rPr lang="de-DE" sz="3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600" dirty="0"/>
        </a:p>
      </dgm:t>
    </dgm:pt>
    <dgm:pt modelId="{C2FFA65D-34CC-4A99-A6E3-97E498A8A7DB}" type="parTrans" cxnId="{024B606F-4E15-4072-ACCC-5F51F1023E20}">
      <dgm:prSet/>
      <dgm:spPr/>
      <dgm:t>
        <a:bodyPr/>
        <a:lstStyle/>
        <a:p>
          <a:endParaRPr lang="de-DE"/>
        </a:p>
      </dgm:t>
    </dgm:pt>
    <dgm:pt modelId="{77F656F1-CCBA-40CA-9E25-3449E8C94086}" type="sibTrans" cxnId="{024B606F-4E15-4072-ACCC-5F51F1023E20}">
      <dgm:prSet/>
      <dgm:spPr/>
      <dgm:t>
        <a:bodyPr/>
        <a:lstStyle/>
        <a:p>
          <a:endParaRPr lang="de-DE"/>
        </a:p>
      </dgm:t>
    </dgm:pt>
    <dgm:pt modelId="{B46665B7-0180-48DA-9291-69CD9409CB92}">
      <dgm:prSet phldrT="[Text]" custT="1"/>
      <dgm:spPr/>
      <dgm:t>
        <a:bodyPr/>
        <a:lstStyle/>
        <a:p>
          <a:r>
            <a:rPr lang="de-DE" sz="2400" dirty="0"/>
            <a:t>LDL </a:t>
          </a:r>
          <a:r>
            <a:rPr lang="de-DE" sz="2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r>
            <a:rPr lang="en-GB" sz="900" dirty="0"/>
            <a:t>β=0.008 mm per mg/dl</a:t>
          </a:r>
          <a:endParaRPr lang="de-DE" sz="900" dirty="0"/>
        </a:p>
      </dgm:t>
    </dgm:pt>
    <dgm:pt modelId="{A2A41AC0-28E2-45C4-BA6C-74301B374D28}" type="parTrans" cxnId="{A2FFDF77-1053-44D7-929E-293831C76749}">
      <dgm:prSet/>
      <dgm:spPr/>
      <dgm:t>
        <a:bodyPr/>
        <a:lstStyle/>
        <a:p>
          <a:endParaRPr lang="de-DE"/>
        </a:p>
      </dgm:t>
    </dgm:pt>
    <dgm:pt modelId="{B72CB4EC-EF62-45BA-8DD5-C8923A1A2AB3}" type="sibTrans" cxnId="{A2FFDF77-1053-44D7-929E-293831C76749}">
      <dgm:prSet/>
      <dgm:spPr/>
      <dgm:t>
        <a:bodyPr/>
        <a:lstStyle/>
        <a:p>
          <a:endParaRPr lang="de-DE"/>
        </a:p>
      </dgm:t>
    </dgm:pt>
    <dgm:pt modelId="{0D4299F0-B4C2-4B43-8397-4F3D226C234F}">
      <dgm:prSet phldrT="[Text]" custT="1"/>
      <dgm:spPr/>
      <dgm:t>
        <a:bodyPr/>
        <a:lstStyle/>
        <a:p>
          <a:r>
            <a:rPr lang="de-DE" sz="2400" dirty="0"/>
            <a:t>Age </a:t>
          </a:r>
          <a:r>
            <a:rPr lang="de-DE" sz="2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r>
            <a:rPr lang="en-GB" sz="900" dirty="0"/>
            <a:t>β=0.038 mm per year</a:t>
          </a:r>
          <a:endParaRPr lang="de-DE" sz="900" dirty="0"/>
        </a:p>
      </dgm:t>
    </dgm:pt>
    <dgm:pt modelId="{AAD44C85-2F83-432F-94F1-0874C2900687}" type="parTrans" cxnId="{746C28D0-267F-4F68-BF17-14CBDA43270E}">
      <dgm:prSet/>
      <dgm:spPr/>
      <dgm:t>
        <a:bodyPr/>
        <a:lstStyle/>
        <a:p>
          <a:endParaRPr lang="de-DE"/>
        </a:p>
      </dgm:t>
    </dgm:pt>
    <dgm:pt modelId="{C477DEC7-C088-4B1F-A832-A5A188DE434E}" type="sibTrans" cxnId="{746C28D0-267F-4F68-BF17-14CBDA43270E}">
      <dgm:prSet/>
      <dgm:spPr/>
      <dgm:t>
        <a:bodyPr/>
        <a:lstStyle/>
        <a:p>
          <a:endParaRPr lang="de-DE"/>
        </a:p>
      </dgm:t>
    </dgm:pt>
    <dgm:pt modelId="{3AF7D5B9-DFF6-48E5-9496-7B66051B9EFE}">
      <dgm:prSet phldrT="[Text]" custT="1"/>
      <dgm:spPr/>
      <dgm:t>
        <a:bodyPr/>
        <a:lstStyle/>
        <a:p>
          <a:r>
            <a:rPr lang="de-DE" sz="2400" dirty="0"/>
            <a:t>BMI </a:t>
          </a:r>
          <a:r>
            <a:rPr lang="de-DE" sz="2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r>
            <a:rPr lang="en-GB" sz="900" dirty="0"/>
            <a:t>β=0.097 mm per kg/m²</a:t>
          </a:r>
          <a:endParaRPr lang="de-DE" sz="900" dirty="0"/>
        </a:p>
      </dgm:t>
    </dgm:pt>
    <dgm:pt modelId="{34552B53-2A67-4424-9D7D-FAD8BDE33ECD}" type="parTrans" cxnId="{0AACBC29-CD04-41C4-AF1E-D1B0FB65F1C9}">
      <dgm:prSet/>
      <dgm:spPr/>
      <dgm:t>
        <a:bodyPr/>
        <a:lstStyle/>
        <a:p>
          <a:endParaRPr lang="de-DE"/>
        </a:p>
      </dgm:t>
    </dgm:pt>
    <dgm:pt modelId="{12738202-D6B4-4D26-9575-5075B37432CE}" type="sibTrans" cxnId="{0AACBC29-CD04-41C4-AF1E-D1B0FB65F1C9}">
      <dgm:prSet/>
      <dgm:spPr/>
      <dgm:t>
        <a:bodyPr/>
        <a:lstStyle/>
        <a:p>
          <a:endParaRPr lang="de-DE"/>
        </a:p>
      </dgm:t>
    </dgm:pt>
    <dgm:pt modelId="{386D7B7F-04B8-471E-BFAA-A770A30815FF}" type="pres">
      <dgm:prSet presAssocID="{DBDBE6A1-D088-4F00-BCE9-86AA6D260958}" presName="cycle" presStyleCnt="0">
        <dgm:presLayoutVars>
          <dgm:chMax val="1"/>
          <dgm:dir/>
          <dgm:animLvl val="ctr"/>
          <dgm:resizeHandles val="exact"/>
        </dgm:presLayoutVars>
      </dgm:prSet>
      <dgm:spPr/>
    </dgm:pt>
    <dgm:pt modelId="{F4A31D34-42A7-4631-B561-0F4EF5E50D5C}" type="pres">
      <dgm:prSet presAssocID="{6367C59A-8C5B-4270-B7C1-0DA7F52229F7}" presName="centerShape" presStyleLbl="node0" presStyleIdx="0" presStyleCnt="1" custScaleX="141142" custScaleY="141676" custLinFactNeighborX="11331" custLinFactNeighborY="-22736"/>
      <dgm:spPr/>
    </dgm:pt>
    <dgm:pt modelId="{72D9C816-81FB-497A-95CB-D00700E5EB82}" type="pres">
      <dgm:prSet presAssocID="{A2A41AC0-28E2-45C4-BA6C-74301B374D28}" presName="parTrans" presStyleLbl="bgSibTrans2D1" presStyleIdx="0" presStyleCnt="3" custLinFactNeighborX="-341" custLinFactNeighborY="-6082"/>
      <dgm:spPr/>
    </dgm:pt>
    <dgm:pt modelId="{1FEDEC01-4661-4AE5-AE3C-CC7D19EF12D2}" type="pres">
      <dgm:prSet presAssocID="{B46665B7-0180-48DA-9291-69CD9409CB92}" presName="node" presStyleLbl="node1" presStyleIdx="0" presStyleCnt="3" custScaleX="87550" custScaleY="61699" custRadScaleRad="88987" custRadScaleInc="-74518">
        <dgm:presLayoutVars>
          <dgm:bulletEnabled val="1"/>
        </dgm:presLayoutVars>
      </dgm:prSet>
      <dgm:spPr/>
    </dgm:pt>
    <dgm:pt modelId="{0DE0D7A6-BAB8-4F12-B563-772A2CCA5886}" type="pres">
      <dgm:prSet presAssocID="{AAD44C85-2F83-432F-94F1-0874C2900687}" presName="parTrans" presStyleLbl="bgSibTrans2D1" presStyleIdx="1" presStyleCnt="3"/>
      <dgm:spPr/>
    </dgm:pt>
    <dgm:pt modelId="{3F235D20-8643-46B7-8769-4CAED7B2F582}" type="pres">
      <dgm:prSet presAssocID="{0D4299F0-B4C2-4B43-8397-4F3D226C234F}" presName="node" presStyleLbl="node1" presStyleIdx="1" presStyleCnt="3" custScaleX="89165" custScaleY="60306" custRadScaleRad="132657" custRadScaleInc="-67090">
        <dgm:presLayoutVars>
          <dgm:bulletEnabled val="1"/>
        </dgm:presLayoutVars>
      </dgm:prSet>
      <dgm:spPr/>
    </dgm:pt>
    <dgm:pt modelId="{38267C99-D6DB-41E7-84D1-CC9D0A9E3C4F}" type="pres">
      <dgm:prSet presAssocID="{34552B53-2A67-4424-9D7D-FAD8BDE33ECD}" presName="parTrans" presStyleLbl="bgSibTrans2D1" presStyleIdx="2" presStyleCnt="3"/>
      <dgm:spPr/>
    </dgm:pt>
    <dgm:pt modelId="{C713D318-9C9D-4D8F-B585-C60DBED0CB92}" type="pres">
      <dgm:prSet presAssocID="{3AF7D5B9-DFF6-48E5-9496-7B66051B9EFE}" presName="node" presStyleLbl="node1" presStyleIdx="2" presStyleCnt="3" custScaleX="89864" custScaleY="60297" custRadScaleRad="97215" custRadScaleInc="-197884">
        <dgm:presLayoutVars>
          <dgm:bulletEnabled val="1"/>
        </dgm:presLayoutVars>
      </dgm:prSet>
      <dgm:spPr/>
    </dgm:pt>
  </dgm:ptLst>
  <dgm:cxnLst>
    <dgm:cxn modelId="{0AACBC29-CD04-41C4-AF1E-D1B0FB65F1C9}" srcId="{6367C59A-8C5B-4270-B7C1-0DA7F52229F7}" destId="{3AF7D5B9-DFF6-48E5-9496-7B66051B9EFE}" srcOrd="2" destOrd="0" parTransId="{34552B53-2A67-4424-9D7D-FAD8BDE33ECD}" sibTransId="{12738202-D6B4-4D26-9575-5075B37432CE}"/>
    <dgm:cxn modelId="{CA65D03F-89D0-4F2C-931C-9495AD957719}" type="presOf" srcId="{6367C59A-8C5B-4270-B7C1-0DA7F52229F7}" destId="{F4A31D34-42A7-4631-B561-0F4EF5E50D5C}" srcOrd="0" destOrd="0" presId="urn:microsoft.com/office/officeart/2005/8/layout/radial4"/>
    <dgm:cxn modelId="{1AB6E85F-8686-4090-9280-5D5B47F803FD}" type="presOf" srcId="{B46665B7-0180-48DA-9291-69CD9409CB92}" destId="{1FEDEC01-4661-4AE5-AE3C-CC7D19EF12D2}" srcOrd="0" destOrd="0" presId="urn:microsoft.com/office/officeart/2005/8/layout/radial4"/>
    <dgm:cxn modelId="{38F49B66-486B-4A32-8443-6E10CE81FE6C}" type="presOf" srcId="{0D4299F0-B4C2-4B43-8397-4F3D226C234F}" destId="{3F235D20-8643-46B7-8769-4CAED7B2F582}" srcOrd="0" destOrd="0" presId="urn:microsoft.com/office/officeart/2005/8/layout/radial4"/>
    <dgm:cxn modelId="{024B606F-4E15-4072-ACCC-5F51F1023E20}" srcId="{DBDBE6A1-D088-4F00-BCE9-86AA6D260958}" destId="{6367C59A-8C5B-4270-B7C1-0DA7F52229F7}" srcOrd="0" destOrd="0" parTransId="{C2FFA65D-34CC-4A99-A6E3-97E498A8A7DB}" sibTransId="{77F656F1-CCBA-40CA-9E25-3449E8C94086}"/>
    <dgm:cxn modelId="{3DFB3553-BBDA-4698-8129-CF99B8BEE205}" type="presOf" srcId="{DBDBE6A1-D088-4F00-BCE9-86AA6D260958}" destId="{386D7B7F-04B8-471E-BFAA-A770A30815FF}" srcOrd="0" destOrd="0" presId="urn:microsoft.com/office/officeart/2005/8/layout/radial4"/>
    <dgm:cxn modelId="{A2FFDF77-1053-44D7-929E-293831C76749}" srcId="{6367C59A-8C5B-4270-B7C1-0DA7F52229F7}" destId="{B46665B7-0180-48DA-9291-69CD9409CB92}" srcOrd="0" destOrd="0" parTransId="{A2A41AC0-28E2-45C4-BA6C-74301B374D28}" sibTransId="{B72CB4EC-EF62-45BA-8DD5-C8923A1A2AB3}"/>
    <dgm:cxn modelId="{B5BA238F-B252-4B88-A0F2-8821EF0C5143}" type="presOf" srcId="{A2A41AC0-28E2-45C4-BA6C-74301B374D28}" destId="{72D9C816-81FB-497A-95CB-D00700E5EB82}" srcOrd="0" destOrd="0" presId="urn:microsoft.com/office/officeart/2005/8/layout/radial4"/>
    <dgm:cxn modelId="{130AB4A1-B372-4FE6-B605-DCB660897944}" type="presOf" srcId="{AAD44C85-2F83-432F-94F1-0874C2900687}" destId="{0DE0D7A6-BAB8-4F12-B563-772A2CCA5886}" srcOrd="0" destOrd="0" presId="urn:microsoft.com/office/officeart/2005/8/layout/radial4"/>
    <dgm:cxn modelId="{F4F658A3-8392-4701-B7DA-7B18F19FC482}" type="presOf" srcId="{34552B53-2A67-4424-9D7D-FAD8BDE33ECD}" destId="{38267C99-D6DB-41E7-84D1-CC9D0A9E3C4F}" srcOrd="0" destOrd="0" presId="urn:microsoft.com/office/officeart/2005/8/layout/radial4"/>
    <dgm:cxn modelId="{52B889BE-B5B7-451A-8868-087744426A13}" type="presOf" srcId="{3AF7D5B9-DFF6-48E5-9496-7B66051B9EFE}" destId="{C713D318-9C9D-4D8F-B585-C60DBED0CB92}" srcOrd="0" destOrd="0" presId="urn:microsoft.com/office/officeart/2005/8/layout/radial4"/>
    <dgm:cxn modelId="{746C28D0-267F-4F68-BF17-14CBDA43270E}" srcId="{6367C59A-8C5B-4270-B7C1-0DA7F52229F7}" destId="{0D4299F0-B4C2-4B43-8397-4F3D226C234F}" srcOrd="1" destOrd="0" parTransId="{AAD44C85-2F83-432F-94F1-0874C2900687}" sibTransId="{C477DEC7-C088-4B1F-A832-A5A188DE434E}"/>
    <dgm:cxn modelId="{0FEBA46E-96D1-4BE4-BF07-E3BEA3E59306}" type="presParOf" srcId="{386D7B7F-04B8-471E-BFAA-A770A30815FF}" destId="{F4A31D34-42A7-4631-B561-0F4EF5E50D5C}" srcOrd="0" destOrd="0" presId="urn:microsoft.com/office/officeart/2005/8/layout/radial4"/>
    <dgm:cxn modelId="{7123E7F3-DFCE-4E98-A506-7B6286AE7424}" type="presParOf" srcId="{386D7B7F-04B8-471E-BFAA-A770A30815FF}" destId="{72D9C816-81FB-497A-95CB-D00700E5EB82}" srcOrd="1" destOrd="0" presId="urn:microsoft.com/office/officeart/2005/8/layout/radial4"/>
    <dgm:cxn modelId="{2EA6701A-851F-4581-9A0F-CA9BDC1E4A19}" type="presParOf" srcId="{386D7B7F-04B8-471E-BFAA-A770A30815FF}" destId="{1FEDEC01-4661-4AE5-AE3C-CC7D19EF12D2}" srcOrd="2" destOrd="0" presId="urn:microsoft.com/office/officeart/2005/8/layout/radial4"/>
    <dgm:cxn modelId="{6F786F05-B313-4DEB-9BFD-770B3099D3BB}" type="presParOf" srcId="{386D7B7F-04B8-471E-BFAA-A770A30815FF}" destId="{0DE0D7A6-BAB8-4F12-B563-772A2CCA5886}" srcOrd="3" destOrd="0" presId="urn:microsoft.com/office/officeart/2005/8/layout/radial4"/>
    <dgm:cxn modelId="{16044226-C199-47CA-A85D-EA9F5F29BB42}" type="presParOf" srcId="{386D7B7F-04B8-471E-BFAA-A770A30815FF}" destId="{3F235D20-8643-46B7-8769-4CAED7B2F582}" srcOrd="4" destOrd="0" presId="urn:microsoft.com/office/officeart/2005/8/layout/radial4"/>
    <dgm:cxn modelId="{358CEB2A-F651-4D5E-B8E1-3707B098B11F}" type="presParOf" srcId="{386D7B7F-04B8-471E-BFAA-A770A30815FF}" destId="{38267C99-D6DB-41E7-84D1-CC9D0A9E3C4F}" srcOrd="5" destOrd="0" presId="urn:microsoft.com/office/officeart/2005/8/layout/radial4"/>
    <dgm:cxn modelId="{FAC5B7F6-F68A-4895-BC24-E2BEC00F0304}" type="presParOf" srcId="{386D7B7F-04B8-471E-BFAA-A770A30815FF}" destId="{C713D318-9C9D-4D8F-B585-C60DBED0CB92}" srcOrd="6" destOrd="0" presId="urn:microsoft.com/office/officeart/2005/8/layout/radial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6903B014-89C4-4905-88A7-F969035B0598}" type="doc">
      <dgm:prSet loTypeId="urn:microsoft.com/office/officeart/2005/8/layout/equation2" loCatId="relationship" qsTypeId="urn:microsoft.com/office/officeart/2005/8/quickstyle/simple1" qsCatId="simple" csTypeId="urn:microsoft.com/office/officeart/2005/8/colors/accent1_2" csCatId="accent1" phldr="1"/>
      <dgm:spPr/>
    </dgm:pt>
    <dgm:pt modelId="{82FD2C93-8CB9-4EDD-A0FB-BF6825D810E2}">
      <dgm:prSet phldrT="[Text]" custT="1"/>
      <dgm:spPr/>
      <dgm:t>
        <a:bodyPr/>
        <a:lstStyle/>
        <a:p>
          <a:r>
            <a:rPr lang="de-DE" sz="3600" dirty="0"/>
            <a:t>EAT </a:t>
          </a:r>
          <a:r>
            <a:rPr lang="de-DE" sz="3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600" dirty="0"/>
        </a:p>
      </dgm:t>
    </dgm:pt>
    <dgm:pt modelId="{3F5A0E77-30FA-41F2-B802-0184399906E1}" type="parTrans" cxnId="{0EAED19D-4316-4A15-B7D4-497B7CB85270}">
      <dgm:prSet/>
      <dgm:spPr/>
      <dgm:t>
        <a:bodyPr/>
        <a:lstStyle/>
        <a:p>
          <a:endParaRPr lang="de-DE"/>
        </a:p>
      </dgm:t>
    </dgm:pt>
    <dgm:pt modelId="{BE3EE86F-EF01-4B19-91B9-08178F7A011A}" type="sibTrans" cxnId="{0EAED19D-4316-4A15-B7D4-497B7CB85270}">
      <dgm:prSet/>
      <dgm:spPr/>
      <dgm:t>
        <a:bodyPr/>
        <a:lstStyle/>
        <a:p>
          <a:endParaRPr lang="de-DE"/>
        </a:p>
      </dgm:t>
    </dgm:pt>
    <dgm:pt modelId="{94248E9E-A804-4EE2-8AAA-E9999B3486F6}">
      <dgm:prSet phldrT="[Text]" custT="1"/>
      <dgm:spPr/>
      <dgm:t>
        <a:bodyPr/>
        <a:lstStyle/>
        <a:p>
          <a:r>
            <a:rPr lang="de-DE" sz="3200" dirty="0"/>
            <a:t>LVH </a:t>
          </a:r>
          <a:r>
            <a:rPr lang="de-DE" sz="3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200" dirty="0"/>
        </a:p>
      </dgm:t>
    </dgm:pt>
    <dgm:pt modelId="{E4B3A217-42E7-4A86-9814-53EBA4264788}" type="parTrans" cxnId="{7EAB1727-70A6-4DF4-8F4C-A553DCE31985}">
      <dgm:prSet/>
      <dgm:spPr/>
      <dgm:t>
        <a:bodyPr/>
        <a:lstStyle/>
        <a:p>
          <a:endParaRPr lang="de-DE"/>
        </a:p>
      </dgm:t>
    </dgm:pt>
    <dgm:pt modelId="{6BCA9E0D-E33A-4B93-A693-75AB31E16A20}" type="sibTrans" cxnId="{7EAB1727-70A6-4DF4-8F4C-A553DCE31985}">
      <dgm:prSet/>
      <dgm:spPr/>
      <dgm:t>
        <a:bodyPr/>
        <a:lstStyle/>
        <a:p>
          <a:endParaRPr lang="de-DE"/>
        </a:p>
      </dgm:t>
    </dgm:pt>
    <dgm:pt modelId="{091F9354-9CDD-440C-9592-3AFD792653BF}" type="pres">
      <dgm:prSet presAssocID="{6903B014-89C4-4905-88A7-F969035B0598}" presName="Name0" presStyleCnt="0">
        <dgm:presLayoutVars>
          <dgm:dir/>
          <dgm:resizeHandles val="exact"/>
        </dgm:presLayoutVars>
      </dgm:prSet>
      <dgm:spPr/>
    </dgm:pt>
    <dgm:pt modelId="{EDD727D2-E3F3-445C-A065-B0E512CF784F}" type="pres">
      <dgm:prSet presAssocID="{6903B014-89C4-4905-88A7-F969035B0598}" presName="vNodes" presStyleCnt="0"/>
      <dgm:spPr/>
    </dgm:pt>
    <dgm:pt modelId="{6957A74D-0222-4B57-89DB-44E6B83AA236}" type="pres">
      <dgm:prSet presAssocID="{82FD2C93-8CB9-4EDD-A0FB-BF6825D810E2}" presName="node" presStyleLbl="node1" presStyleIdx="0" presStyleCnt="2" custScaleX="115226" custScaleY="113250" custLinFactNeighborX="4940" custLinFactNeighborY="-894">
        <dgm:presLayoutVars>
          <dgm:bulletEnabled val="1"/>
        </dgm:presLayoutVars>
      </dgm:prSet>
      <dgm:spPr/>
    </dgm:pt>
    <dgm:pt modelId="{367F8417-8DA6-4EC4-AB39-A39F2927630E}" type="pres">
      <dgm:prSet presAssocID="{6903B014-89C4-4905-88A7-F969035B0598}" presName="sibTransLast" presStyleLbl="sibTrans2D1" presStyleIdx="0" presStyleCnt="1"/>
      <dgm:spPr/>
    </dgm:pt>
    <dgm:pt modelId="{A5388361-DE0F-48B4-B3C6-24CA1C10ED61}" type="pres">
      <dgm:prSet presAssocID="{6903B014-89C4-4905-88A7-F969035B0598}" presName="connectorText" presStyleLbl="sibTrans2D1" presStyleIdx="0" presStyleCnt="1"/>
      <dgm:spPr/>
    </dgm:pt>
    <dgm:pt modelId="{CE7CFA3A-FD89-4FD7-A4F5-AA052CA32FE9}" type="pres">
      <dgm:prSet presAssocID="{6903B014-89C4-4905-88A7-F969035B0598}" presName="lastNode" presStyleLbl="node1" presStyleIdx="1" presStyleCnt="2" custScaleX="118126" custScaleY="117161" custLinFactNeighborX="-8485" custLinFactNeighborY="-463">
        <dgm:presLayoutVars>
          <dgm:bulletEnabled val="1"/>
        </dgm:presLayoutVars>
      </dgm:prSet>
      <dgm:spPr/>
    </dgm:pt>
  </dgm:ptLst>
  <dgm:cxnLst>
    <dgm:cxn modelId="{E6EF5609-D115-4AC1-95DD-A183C7A22B40}" type="presOf" srcId="{BE3EE86F-EF01-4B19-91B9-08178F7A011A}" destId="{367F8417-8DA6-4EC4-AB39-A39F2927630E}" srcOrd="0" destOrd="0" presId="urn:microsoft.com/office/officeart/2005/8/layout/equation2"/>
    <dgm:cxn modelId="{4C7AD026-A159-44AB-A7D3-3C48F48C81ED}" type="presOf" srcId="{94248E9E-A804-4EE2-8AAA-E9999B3486F6}" destId="{CE7CFA3A-FD89-4FD7-A4F5-AA052CA32FE9}" srcOrd="0" destOrd="0" presId="urn:microsoft.com/office/officeart/2005/8/layout/equation2"/>
    <dgm:cxn modelId="{7EAB1727-70A6-4DF4-8F4C-A553DCE31985}" srcId="{6903B014-89C4-4905-88A7-F969035B0598}" destId="{94248E9E-A804-4EE2-8AAA-E9999B3486F6}" srcOrd="1" destOrd="0" parTransId="{E4B3A217-42E7-4A86-9814-53EBA4264788}" sibTransId="{6BCA9E0D-E33A-4B93-A693-75AB31E16A20}"/>
    <dgm:cxn modelId="{1DD2EF3F-EA3B-4C10-B914-BB591E4355D8}" type="presOf" srcId="{6903B014-89C4-4905-88A7-F969035B0598}" destId="{091F9354-9CDD-440C-9592-3AFD792653BF}" srcOrd="0" destOrd="0" presId="urn:microsoft.com/office/officeart/2005/8/layout/equation2"/>
    <dgm:cxn modelId="{2E380B5A-C94D-43EF-9687-2B74F43195DB}" type="presOf" srcId="{82FD2C93-8CB9-4EDD-A0FB-BF6825D810E2}" destId="{6957A74D-0222-4B57-89DB-44E6B83AA236}" srcOrd="0" destOrd="0" presId="urn:microsoft.com/office/officeart/2005/8/layout/equation2"/>
    <dgm:cxn modelId="{0EAED19D-4316-4A15-B7D4-497B7CB85270}" srcId="{6903B014-89C4-4905-88A7-F969035B0598}" destId="{82FD2C93-8CB9-4EDD-A0FB-BF6825D810E2}" srcOrd="0" destOrd="0" parTransId="{3F5A0E77-30FA-41F2-B802-0184399906E1}" sibTransId="{BE3EE86F-EF01-4B19-91B9-08178F7A011A}"/>
    <dgm:cxn modelId="{F27F65C6-7459-47E6-8316-64D13F48292C}" type="presOf" srcId="{BE3EE86F-EF01-4B19-91B9-08178F7A011A}" destId="{A5388361-DE0F-48B4-B3C6-24CA1C10ED61}" srcOrd="1" destOrd="0" presId="urn:microsoft.com/office/officeart/2005/8/layout/equation2"/>
    <dgm:cxn modelId="{82AE4A5A-413E-4593-A201-133437F9CCFE}" type="presParOf" srcId="{091F9354-9CDD-440C-9592-3AFD792653BF}" destId="{EDD727D2-E3F3-445C-A065-B0E512CF784F}" srcOrd="0" destOrd="0" presId="urn:microsoft.com/office/officeart/2005/8/layout/equation2"/>
    <dgm:cxn modelId="{983F67DD-DE53-418E-880C-2624450C7BAD}" type="presParOf" srcId="{EDD727D2-E3F3-445C-A065-B0E512CF784F}" destId="{6957A74D-0222-4B57-89DB-44E6B83AA236}" srcOrd="0" destOrd="0" presId="urn:microsoft.com/office/officeart/2005/8/layout/equation2"/>
    <dgm:cxn modelId="{AB3D513D-89B1-49BD-AB53-BF5116E5FFF4}" type="presParOf" srcId="{091F9354-9CDD-440C-9592-3AFD792653BF}" destId="{367F8417-8DA6-4EC4-AB39-A39F2927630E}" srcOrd="1" destOrd="0" presId="urn:microsoft.com/office/officeart/2005/8/layout/equation2"/>
    <dgm:cxn modelId="{5F19AC7F-4F07-4F94-8903-1FC087BFE4BB}" type="presParOf" srcId="{367F8417-8DA6-4EC4-AB39-A39F2927630E}" destId="{A5388361-DE0F-48B4-B3C6-24CA1C10ED61}" srcOrd="0" destOrd="0" presId="urn:microsoft.com/office/officeart/2005/8/layout/equation2"/>
    <dgm:cxn modelId="{920D032A-2537-4B37-9D15-3E5F856DFED1}" type="presParOf" srcId="{091F9354-9CDD-440C-9592-3AFD792653BF}" destId="{CE7CFA3A-FD89-4FD7-A4F5-AA052CA32FE9}" srcOrd="2" destOrd="0" presId="urn:microsoft.com/office/officeart/2005/8/layout/equation2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BC7E381C-2939-4F29-8503-D06742F1A85B}" type="doc">
      <dgm:prSet loTypeId="urn:microsoft.com/office/officeart/2005/8/layout/process1" loCatId="process" qsTypeId="urn:microsoft.com/office/officeart/2005/8/quickstyle/simple1" qsCatId="simple" csTypeId="urn:microsoft.com/office/officeart/2005/8/colors/accent1_2" csCatId="accent1" phldr="1"/>
      <dgm:spPr/>
    </dgm:pt>
    <dgm:pt modelId="{0FA4180B-1F47-4D1D-BA9D-B6B363CF8FB9}">
      <dgm:prSet phldrT="[Text]"/>
      <dgm:spPr/>
      <dgm:t>
        <a:bodyPr/>
        <a:lstStyle/>
        <a:p>
          <a:r>
            <a:rPr lang="de-DE" dirty="0"/>
            <a:t>988 </a:t>
          </a:r>
          <a:r>
            <a:rPr lang="de-DE" dirty="0" err="1"/>
            <a:t>Probands</a:t>
          </a:r>
          <a:r>
            <a:rPr lang="de-DE" dirty="0"/>
            <a:t> </a:t>
          </a:r>
          <a:r>
            <a:rPr lang="de-DE" dirty="0" err="1"/>
            <a:t>from</a:t>
          </a:r>
          <a:r>
            <a:rPr lang="de-DE" dirty="0"/>
            <a:t> </a:t>
          </a:r>
          <a:r>
            <a:rPr lang="de-DE" dirty="0" err="1"/>
            <a:t>the</a:t>
          </a:r>
          <a:r>
            <a:rPr lang="de-DE" dirty="0"/>
            <a:t> </a:t>
          </a:r>
          <a:r>
            <a:rPr lang="de-DE" dirty="0" err="1"/>
            <a:t>AugUR</a:t>
          </a:r>
          <a:r>
            <a:rPr lang="de-DE" dirty="0"/>
            <a:t>-Trial </a:t>
          </a:r>
        </a:p>
        <a:p>
          <a:r>
            <a:rPr lang="de-DE" dirty="0"/>
            <a:t>(</a:t>
          </a:r>
          <a:r>
            <a:rPr lang="de-DE" dirty="0" err="1"/>
            <a:t>aged</a:t>
          </a:r>
          <a:r>
            <a:rPr lang="de-DE" dirty="0"/>
            <a:t> 70-94)</a:t>
          </a:r>
        </a:p>
      </dgm:t>
    </dgm:pt>
    <dgm:pt modelId="{6D925C40-66AC-4CA1-8A8D-9A9CEDC63917}" type="parTrans" cxnId="{B6CB8ECB-D65A-49C4-8B01-454CC36CA2FD}">
      <dgm:prSet/>
      <dgm:spPr/>
      <dgm:t>
        <a:bodyPr/>
        <a:lstStyle/>
        <a:p>
          <a:endParaRPr lang="de-DE"/>
        </a:p>
      </dgm:t>
    </dgm:pt>
    <dgm:pt modelId="{94EEA475-8B30-4A05-A30B-7A3185C2ACD1}" type="sibTrans" cxnId="{B6CB8ECB-D65A-49C4-8B01-454CC36CA2FD}">
      <dgm:prSet/>
      <dgm:spPr/>
      <dgm:t>
        <a:bodyPr/>
        <a:lstStyle/>
        <a:p>
          <a:endParaRPr lang="de-DE"/>
        </a:p>
      </dgm:t>
    </dgm:pt>
    <dgm:pt modelId="{A81AEAA9-A633-45EB-9EA0-6F3399FDBE19}">
      <dgm:prSet phldrT="[Text]"/>
      <dgm:spPr/>
      <dgm:t>
        <a:bodyPr/>
        <a:lstStyle/>
        <a:p>
          <a:r>
            <a:rPr lang="de-DE" dirty="0"/>
            <a:t>EAT + LV </a:t>
          </a:r>
          <a:r>
            <a:rPr lang="de-DE" dirty="0" err="1"/>
            <a:t>geometry</a:t>
          </a:r>
          <a:r>
            <a:rPr lang="de-DE" dirty="0"/>
            <a:t> </a:t>
          </a:r>
          <a:r>
            <a:rPr lang="de-DE" dirty="0" err="1"/>
            <a:t>measured</a:t>
          </a:r>
          <a:r>
            <a:rPr lang="de-DE" dirty="0"/>
            <a:t> via </a:t>
          </a:r>
          <a:r>
            <a:rPr lang="de-DE" dirty="0" err="1"/>
            <a:t>echocardiography</a:t>
          </a:r>
          <a:endParaRPr lang="de-DE" dirty="0"/>
        </a:p>
      </dgm:t>
    </dgm:pt>
    <dgm:pt modelId="{F5B0845F-9E82-40C0-AEBB-984E652F6B72}" type="parTrans" cxnId="{FAFCB74E-5C7B-414F-8F2C-FB60854DACE2}">
      <dgm:prSet/>
      <dgm:spPr/>
      <dgm:t>
        <a:bodyPr/>
        <a:lstStyle/>
        <a:p>
          <a:endParaRPr lang="de-DE"/>
        </a:p>
      </dgm:t>
    </dgm:pt>
    <dgm:pt modelId="{49AF6877-F1BF-4A2F-A527-FF2385E9BFFB}" type="sibTrans" cxnId="{FAFCB74E-5C7B-414F-8F2C-FB60854DACE2}">
      <dgm:prSet/>
      <dgm:spPr/>
      <dgm:t>
        <a:bodyPr/>
        <a:lstStyle/>
        <a:p>
          <a:endParaRPr lang="de-DE"/>
        </a:p>
      </dgm:t>
    </dgm:pt>
    <dgm:pt modelId="{2C52C4F1-CEE9-4CE3-9A67-AE61AB6EED6D}" type="pres">
      <dgm:prSet presAssocID="{BC7E381C-2939-4F29-8503-D06742F1A85B}" presName="Name0" presStyleCnt="0">
        <dgm:presLayoutVars>
          <dgm:dir/>
          <dgm:resizeHandles val="exact"/>
        </dgm:presLayoutVars>
      </dgm:prSet>
      <dgm:spPr/>
    </dgm:pt>
    <dgm:pt modelId="{C8E5ED40-4DDA-44AA-BB5E-4E23AC427B61}" type="pres">
      <dgm:prSet presAssocID="{0FA4180B-1F47-4D1D-BA9D-B6B363CF8FB9}" presName="node" presStyleLbl="node1" presStyleIdx="0" presStyleCnt="2">
        <dgm:presLayoutVars>
          <dgm:bulletEnabled val="1"/>
        </dgm:presLayoutVars>
      </dgm:prSet>
      <dgm:spPr/>
    </dgm:pt>
    <dgm:pt modelId="{8EFADDA9-AED5-4583-AF4F-1D94266F80FC}" type="pres">
      <dgm:prSet presAssocID="{94EEA475-8B30-4A05-A30B-7A3185C2ACD1}" presName="sibTrans" presStyleLbl="sibTrans2D1" presStyleIdx="0" presStyleCnt="1"/>
      <dgm:spPr/>
    </dgm:pt>
    <dgm:pt modelId="{1E1DAC08-297E-450A-96EE-1AAA60320178}" type="pres">
      <dgm:prSet presAssocID="{94EEA475-8B30-4A05-A30B-7A3185C2ACD1}" presName="connectorText" presStyleLbl="sibTrans2D1" presStyleIdx="0" presStyleCnt="1"/>
      <dgm:spPr/>
    </dgm:pt>
    <dgm:pt modelId="{12B1C446-D8F9-42E3-8066-676E3EFDF7AC}" type="pres">
      <dgm:prSet presAssocID="{A81AEAA9-A633-45EB-9EA0-6F3399FDBE19}" presName="node" presStyleLbl="node1" presStyleIdx="1" presStyleCnt="2">
        <dgm:presLayoutVars>
          <dgm:bulletEnabled val="1"/>
        </dgm:presLayoutVars>
      </dgm:prSet>
      <dgm:spPr/>
    </dgm:pt>
  </dgm:ptLst>
  <dgm:cxnLst>
    <dgm:cxn modelId="{8C377A0F-A384-444A-94F0-9FB4E1BB2C08}" type="presOf" srcId="{BC7E381C-2939-4F29-8503-D06742F1A85B}" destId="{2C52C4F1-CEE9-4CE3-9A67-AE61AB6EED6D}" srcOrd="0" destOrd="0" presId="urn:microsoft.com/office/officeart/2005/8/layout/process1"/>
    <dgm:cxn modelId="{AA610124-AACC-4CE9-9663-2C7CA02EBAB3}" type="presOf" srcId="{A81AEAA9-A633-45EB-9EA0-6F3399FDBE19}" destId="{12B1C446-D8F9-42E3-8066-676E3EFDF7AC}" srcOrd="0" destOrd="0" presId="urn:microsoft.com/office/officeart/2005/8/layout/process1"/>
    <dgm:cxn modelId="{BCE1032E-5662-458F-97F0-9BB3C612E0AC}" type="presOf" srcId="{94EEA475-8B30-4A05-A30B-7A3185C2ACD1}" destId="{8EFADDA9-AED5-4583-AF4F-1D94266F80FC}" srcOrd="0" destOrd="0" presId="urn:microsoft.com/office/officeart/2005/8/layout/process1"/>
    <dgm:cxn modelId="{89E8615D-0B4B-4409-9D27-A1A5E910367B}" type="presOf" srcId="{94EEA475-8B30-4A05-A30B-7A3185C2ACD1}" destId="{1E1DAC08-297E-450A-96EE-1AAA60320178}" srcOrd="1" destOrd="0" presId="urn:microsoft.com/office/officeart/2005/8/layout/process1"/>
    <dgm:cxn modelId="{37F0F861-6842-4A39-AFCE-F4250DD90817}" type="presOf" srcId="{0FA4180B-1F47-4D1D-BA9D-B6B363CF8FB9}" destId="{C8E5ED40-4DDA-44AA-BB5E-4E23AC427B61}" srcOrd="0" destOrd="0" presId="urn:microsoft.com/office/officeart/2005/8/layout/process1"/>
    <dgm:cxn modelId="{FAFCB74E-5C7B-414F-8F2C-FB60854DACE2}" srcId="{BC7E381C-2939-4F29-8503-D06742F1A85B}" destId="{A81AEAA9-A633-45EB-9EA0-6F3399FDBE19}" srcOrd="1" destOrd="0" parTransId="{F5B0845F-9E82-40C0-AEBB-984E652F6B72}" sibTransId="{49AF6877-F1BF-4A2F-A527-FF2385E9BFFB}"/>
    <dgm:cxn modelId="{B6CB8ECB-D65A-49C4-8B01-454CC36CA2FD}" srcId="{BC7E381C-2939-4F29-8503-D06742F1A85B}" destId="{0FA4180B-1F47-4D1D-BA9D-B6B363CF8FB9}" srcOrd="0" destOrd="0" parTransId="{6D925C40-66AC-4CA1-8A8D-9A9CEDC63917}" sibTransId="{94EEA475-8B30-4A05-A30B-7A3185C2ACD1}"/>
    <dgm:cxn modelId="{8DAEF5DA-F0D0-4F3C-876E-C84453C1E93C}" type="presParOf" srcId="{2C52C4F1-CEE9-4CE3-9A67-AE61AB6EED6D}" destId="{C8E5ED40-4DDA-44AA-BB5E-4E23AC427B61}" srcOrd="0" destOrd="0" presId="urn:microsoft.com/office/officeart/2005/8/layout/process1"/>
    <dgm:cxn modelId="{E7B1326A-D4B3-41C1-AF07-90D5492C34AF}" type="presParOf" srcId="{2C52C4F1-CEE9-4CE3-9A67-AE61AB6EED6D}" destId="{8EFADDA9-AED5-4583-AF4F-1D94266F80FC}" srcOrd="1" destOrd="0" presId="urn:microsoft.com/office/officeart/2005/8/layout/process1"/>
    <dgm:cxn modelId="{92EF8BE1-A1B5-41B1-BD8C-4C93A3551254}" type="presParOf" srcId="{8EFADDA9-AED5-4583-AF4F-1D94266F80FC}" destId="{1E1DAC08-297E-450A-96EE-1AAA60320178}" srcOrd="0" destOrd="0" presId="urn:microsoft.com/office/officeart/2005/8/layout/process1"/>
    <dgm:cxn modelId="{1488B62B-72CF-4B8C-ACDA-AEFE5C9D629D}" type="presParOf" srcId="{2C52C4F1-CEE9-4CE3-9A67-AE61AB6EED6D}" destId="{12B1C446-D8F9-42E3-8066-676E3EFDF7AC}" srcOrd="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3D684BC5-233D-4161-B95D-FA5611C99DE4}" type="doc">
      <dgm:prSet loTypeId="urn:microsoft.com/office/officeart/2005/8/layout/process1" loCatId="process" qsTypeId="urn:microsoft.com/office/officeart/2005/8/quickstyle/simple1" qsCatId="simple" csTypeId="urn:microsoft.com/office/officeart/2005/8/colors/accent1_2" csCatId="accent1" phldr="1"/>
      <dgm:spPr/>
    </dgm:pt>
    <dgm:pt modelId="{0280DF0E-B220-4B5A-9233-CC2638710A63}">
      <dgm:prSet phldrT="[Text]"/>
      <dgm:spPr/>
      <dgm:t>
        <a:bodyPr/>
        <a:lstStyle/>
        <a:p>
          <a:r>
            <a:rPr lang="de-DE" dirty="0"/>
            <a:t>Age </a:t>
          </a:r>
          <a:r>
            <a:rPr lang="de-DE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dirty="0"/>
        </a:p>
      </dgm:t>
    </dgm:pt>
    <dgm:pt modelId="{2E1C4EF7-ABA3-48F8-8C8E-387F163F12BC}" type="parTrans" cxnId="{F84B57D9-F94A-485D-853B-5F5288307891}">
      <dgm:prSet/>
      <dgm:spPr/>
      <dgm:t>
        <a:bodyPr/>
        <a:lstStyle/>
        <a:p>
          <a:endParaRPr lang="de-DE"/>
        </a:p>
      </dgm:t>
    </dgm:pt>
    <dgm:pt modelId="{AD7E94FE-244E-4F5F-AC04-7A718F7F7555}" type="sibTrans" cxnId="{F84B57D9-F94A-485D-853B-5F5288307891}">
      <dgm:prSet/>
      <dgm:spPr/>
      <dgm:t>
        <a:bodyPr/>
        <a:lstStyle/>
        <a:p>
          <a:endParaRPr lang="de-DE"/>
        </a:p>
      </dgm:t>
    </dgm:pt>
    <dgm:pt modelId="{D4CE7497-4E12-4325-BFE2-8A66305BFBC9}">
      <dgm:prSet phldrT="[Text]"/>
      <dgm:spPr/>
      <dgm:t>
        <a:bodyPr/>
        <a:lstStyle/>
        <a:p>
          <a:r>
            <a:rPr lang="de-DE" dirty="0"/>
            <a:t>EAT </a:t>
          </a:r>
          <a:r>
            <a:rPr lang="de-DE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dirty="0"/>
        </a:p>
      </dgm:t>
    </dgm:pt>
    <dgm:pt modelId="{71F3E36F-CA33-47AE-8034-B1E599091E87}" type="parTrans" cxnId="{622888C7-CAEF-417C-BA99-931872A16C65}">
      <dgm:prSet/>
      <dgm:spPr/>
      <dgm:t>
        <a:bodyPr/>
        <a:lstStyle/>
        <a:p>
          <a:endParaRPr lang="de-DE"/>
        </a:p>
      </dgm:t>
    </dgm:pt>
    <dgm:pt modelId="{B5E292BD-46DE-4F6A-AFE6-37E446E522A0}" type="sibTrans" cxnId="{622888C7-CAEF-417C-BA99-931872A16C65}">
      <dgm:prSet/>
      <dgm:spPr/>
      <dgm:t>
        <a:bodyPr/>
        <a:lstStyle/>
        <a:p>
          <a:endParaRPr lang="de-DE"/>
        </a:p>
      </dgm:t>
    </dgm:pt>
    <dgm:pt modelId="{3D8A67C0-0094-4D51-8735-3164E204BAD8}" type="pres">
      <dgm:prSet presAssocID="{3D684BC5-233D-4161-B95D-FA5611C99DE4}" presName="Name0" presStyleCnt="0">
        <dgm:presLayoutVars>
          <dgm:dir/>
          <dgm:resizeHandles val="exact"/>
        </dgm:presLayoutVars>
      </dgm:prSet>
      <dgm:spPr/>
    </dgm:pt>
    <dgm:pt modelId="{D33D3FEF-0987-406F-B91D-B0638669063A}" type="pres">
      <dgm:prSet presAssocID="{0280DF0E-B220-4B5A-9233-CC2638710A63}" presName="node" presStyleLbl="node1" presStyleIdx="0" presStyleCnt="2">
        <dgm:presLayoutVars>
          <dgm:bulletEnabled val="1"/>
        </dgm:presLayoutVars>
      </dgm:prSet>
      <dgm:spPr/>
    </dgm:pt>
    <dgm:pt modelId="{290DF2AB-6BF9-4742-8DAA-B5DE618875FA}" type="pres">
      <dgm:prSet presAssocID="{AD7E94FE-244E-4F5F-AC04-7A718F7F7555}" presName="sibTrans" presStyleLbl="sibTrans2D1" presStyleIdx="0" presStyleCnt="1"/>
      <dgm:spPr/>
    </dgm:pt>
    <dgm:pt modelId="{9063EC84-6E16-435E-A5B8-C2D105C2FC3A}" type="pres">
      <dgm:prSet presAssocID="{AD7E94FE-244E-4F5F-AC04-7A718F7F7555}" presName="connectorText" presStyleLbl="sibTrans2D1" presStyleIdx="0" presStyleCnt="1"/>
      <dgm:spPr/>
    </dgm:pt>
    <dgm:pt modelId="{272AE1EA-5A95-4B6B-9952-6949F14CEBF6}" type="pres">
      <dgm:prSet presAssocID="{D4CE7497-4E12-4325-BFE2-8A66305BFBC9}" presName="node" presStyleLbl="node1" presStyleIdx="1" presStyleCnt="2">
        <dgm:presLayoutVars>
          <dgm:bulletEnabled val="1"/>
        </dgm:presLayoutVars>
      </dgm:prSet>
      <dgm:spPr/>
    </dgm:pt>
  </dgm:ptLst>
  <dgm:cxnLst>
    <dgm:cxn modelId="{8615E44F-44B4-4EB0-ABEA-A80304694F72}" type="presOf" srcId="{AD7E94FE-244E-4F5F-AC04-7A718F7F7555}" destId="{290DF2AB-6BF9-4742-8DAA-B5DE618875FA}" srcOrd="0" destOrd="0" presId="urn:microsoft.com/office/officeart/2005/8/layout/process1"/>
    <dgm:cxn modelId="{F12E2781-5488-4C71-BAFA-E453CFE01CC4}" type="presOf" srcId="{3D684BC5-233D-4161-B95D-FA5611C99DE4}" destId="{3D8A67C0-0094-4D51-8735-3164E204BAD8}" srcOrd="0" destOrd="0" presId="urn:microsoft.com/office/officeart/2005/8/layout/process1"/>
    <dgm:cxn modelId="{26FE80C7-5AD3-4379-B38C-679118C8AA72}" type="presOf" srcId="{AD7E94FE-244E-4F5F-AC04-7A718F7F7555}" destId="{9063EC84-6E16-435E-A5B8-C2D105C2FC3A}" srcOrd="1" destOrd="0" presId="urn:microsoft.com/office/officeart/2005/8/layout/process1"/>
    <dgm:cxn modelId="{622888C7-CAEF-417C-BA99-931872A16C65}" srcId="{3D684BC5-233D-4161-B95D-FA5611C99DE4}" destId="{D4CE7497-4E12-4325-BFE2-8A66305BFBC9}" srcOrd="1" destOrd="0" parTransId="{71F3E36F-CA33-47AE-8034-B1E599091E87}" sibTransId="{B5E292BD-46DE-4F6A-AFE6-37E446E522A0}"/>
    <dgm:cxn modelId="{7A062DCE-26C9-4231-9688-AB4D7326A921}" type="presOf" srcId="{D4CE7497-4E12-4325-BFE2-8A66305BFBC9}" destId="{272AE1EA-5A95-4B6B-9952-6949F14CEBF6}" srcOrd="0" destOrd="0" presId="urn:microsoft.com/office/officeart/2005/8/layout/process1"/>
    <dgm:cxn modelId="{F84B57D9-F94A-485D-853B-5F5288307891}" srcId="{3D684BC5-233D-4161-B95D-FA5611C99DE4}" destId="{0280DF0E-B220-4B5A-9233-CC2638710A63}" srcOrd="0" destOrd="0" parTransId="{2E1C4EF7-ABA3-48F8-8C8E-387F163F12BC}" sibTransId="{AD7E94FE-244E-4F5F-AC04-7A718F7F7555}"/>
    <dgm:cxn modelId="{2528ABEB-7FC0-4730-89EB-5E3D37D9497D}" type="presOf" srcId="{0280DF0E-B220-4B5A-9233-CC2638710A63}" destId="{D33D3FEF-0987-406F-B91D-B0638669063A}" srcOrd="0" destOrd="0" presId="urn:microsoft.com/office/officeart/2005/8/layout/process1"/>
    <dgm:cxn modelId="{C6FDF5E1-E765-4862-A418-EF7D4415028E}" type="presParOf" srcId="{3D8A67C0-0094-4D51-8735-3164E204BAD8}" destId="{D33D3FEF-0987-406F-B91D-B0638669063A}" srcOrd="0" destOrd="0" presId="urn:microsoft.com/office/officeart/2005/8/layout/process1"/>
    <dgm:cxn modelId="{0BB6C2A0-43CA-4261-AF48-18C77345129F}" type="presParOf" srcId="{3D8A67C0-0094-4D51-8735-3164E204BAD8}" destId="{290DF2AB-6BF9-4742-8DAA-B5DE618875FA}" srcOrd="1" destOrd="0" presId="urn:microsoft.com/office/officeart/2005/8/layout/process1"/>
    <dgm:cxn modelId="{0B7704A1-2D7D-4949-AA0A-115D0D7AF0A0}" type="presParOf" srcId="{290DF2AB-6BF9-4742-8DAA-B5DE618875FA}" destId="{9063EC84-6E16-435E-A5B8-C2D105C2FC3A}" srcOrd="0" destOrd="0" presId="urn:microsoft.com/office/officeart/2005/8/layout/process1"/>
    <dgm:cxn modelId="{2052BFE9-E5B7-4F71-A71B-EC7B63688786}" type="presParOf" srcId="{3D8A67C0-0094-4D51-8735-3164E204BAD8}" destId="{272AE1EA-5A95-4B6B-9952-6949F14CEBF6}" srcOrd="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24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3D684BC5-233D-4161-B95D-FA5611C99DE4}" type="doc">
      <dgm:prSet loTypeId="urn:microsoft.com/office/officeart/2005/8/layout/process1" loCatId="process" qsTypeId="urn:microsoft.com/office/officeart/2005/8/quickstyle/simple1" qsCatId="simple" csTypeId="urn:microsoft.com/office/officeart/2005/8/colors/accent1_2" csCatId="accent1" phldr="1"/>
      <dgm:spPr/>
    </dgm:pt>
    <dgm:pt modelId="{0280DF0E-B220-4B5A-9233-CC2638710A63}">
      <dgm:prSet phldrT="[Text]"/>
      <dgm:spPr/>
      <dgm:t>
        <a:bodyPr/>
        <a:lstStyle/>
        <a:p>
          <a:r>
            <a:rPr lang="de-DE" dirty="0"/>
            <a:t>EAT</a:t>
          </a:r>
          <a:r>
            <a:rPr lang="de-DE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dirty="0"/>
        </a:p>
      </dgm:t>
    </dgm:pt>
    <dgm:pt modelId="{2E1C4EF7-ABA3-48F8-8C8E-387F163F12BC}" type="parTrans" cxnId="{F84B57D9-F94A-485D-853B-5F5288307891}">
      <dgm:prSet/>
      <dgm:spPr/>
      <dgm:t>
        <a:bodyPr/>
        <a:lstStyle/>
        <a:p>
          <a:endParaRPr lang="de-DE"/>
        </a:p>
      </dgm:t>
    </dgm:pt>
    <dgm:pt modelId="{AD7E94FE-244E-4F5F-AC04-7A718F7F7555}" type="sibTrans" cxnId="{F84B57D9-F94A-485D-853B-5F5288307891}">
      <dgm:prSet/>
      <dgm:spPr/>
      <dgm:t>
        <a:bodyPr/>
        <a:lstStyle/>
        <a:p>
          <a:endParaRPr lang="de-DE"/>
        </a:p>
      </dgm:t>
    </dgm:pt>
    <dgm:pt modelId="{D4CE7497-4E12-4325-BFE2-8A66305BFBC9}">
      <dgm:prSet phldrT="[Text]"/>
      <dgm:spPr/>
      <dgm:t>
        <a:bodyPr/>
        <a:lstStyle/>
        <a:p>
          <a:r>
            <a:rPr lang="de-DE" dirty="0"/>
            <a:t>LVM</a:t>
          </a:r>
          <a:r>
            <a:rPr lang="de-DE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dirty="0"/>
        </a:p>
      </dgm:t>
    </dgm:pt>
    <dgm:pt modelId="{71F3E36F-CA33-47AE-8034-B1E599091E87}" type="parTrans" cxnId="{622888C7-CAEF-417C-BA99-931872A16C65}">
      <dgm:prSet/>
      <dgm:spPr/>
      <dgm:t>
        <a:bodyPr/>
        <a:lstStyle/>
        <a:p>
          <a:endParaRPr lang="de-DE"/>
        </a:p>
      </dgm:t>
    </dgm:pt>
    <dgm:pt modelId="{B5E292BD-46DE-4F6A-AFE6-37E446E522A0}" type="sibTrans" cxnId="{622888C7-CAEF-417C-BA99-931872A16C65}">
      <dgm:prSet/>
      <dgm:spPr/>
      <dgm:t>
        <a:bodyPr/>
        <a:lstStyle/>
        <a:p>
          <a:endParaRPr lang="de-DE"/>
        </a:p>
      </dgm:t>
    </dgm:pt>
    <dgm:pt modelId="{3D8A67C0-0094-4D51-8735-3164E204BAD8}" type="pres">
      <dgm:prSet presAssocID="{3D684BC5-233D-4161-B95D-FA5611C99DE4}" presName="Name0" presStyleCnt="0">
        <dgm:presLayoutVars>
          <dgm:dir/>
          <dgm:resizeHandles val="exact"/>
        </dgm:presLayoutVars>
      </dgm:prSet>
      <dgm:spPr/>
    </dgm:pt>
    <dgm:pt modelId="{D33D3FEF-0987-406F-B91D-B0638669063A}" type="pres">
      <dgm:prSet presAssocID="{0280DF0E-B220-4B5A-9233-CC2638710A63}" presName="node" presStyleLbl="node1" presStyleIdx="0" presStyleCnt="2">
        <dgm:presLayoutVars>
          <dgm:bulletEnabled val="1"/>
        </dgm:presLayoutVars>
      </dgm:prSet>
      <dgm:spPr/>
    </dgm:pt>
    <dgm:pt modelId="{290DF2AB-6BF9-4742-8DAA-B5DE618875FA}" type="pres">
      <dgm:prSet presAssocID="{AD7E94FE-244E-4F5F-AC04-7A718F7F7555}" presName="sibTrans" presStyleLbl="sibTrans2D1" presStyleIdx="0" presStyleCnt="1"/>
      <dgm:spPr/>
    </dgm:pt>
    <dgm:pt modelId="{9063EC84-6E16-435E-A5B8-C2D105C2FC3A}" type="pres">
      <dgm:prSet presAssocID="{AD7E94FE-244E-4F5F-AC04-7A718F7F7555}" presName="connectorText" presStyleLbl="sibTrans2D1" presStyleIdx="0" presStyleCnt="1"/>
      <dgm:spPr/>
    </dgm:pt>
    <dgm:pt modelId="{272AE1EA-5A95-4B6B-9952-6949F14CEBF6}" type="pres">
      <dgm:prSet presAssocID="{D4CE7497-4E12-4325-BFE2-8A66305BFBC9}" presName="node" presStyleLbl="node1" presStyleIdx="1" presStyleCnt="2">
        <dgm:presLayoutVars>
          <dgm:bulletEnabled val="1"/>
        </dgm:presLayoutVars>
      </dgm:prSet>
      <dgm:spPr/>
    </dgm:pt>
  </dgm:ptLst>
  <dgm:cxnLst>
    <dgm:cxn modelId="{8615E44F-44B4-4EB0-ABEA-A80304694F72}" type="presOf" srcId="{AD7E94FE-244E-4F5F-AC04-7A718F7F7555}" destId="{290DF2AB-6BF9-4742-8DAA-B5DE618875FA}" srcOrd="0" destOrd="0" presId="urn:microsoft.com/office/officeart/2005/8/layout/process1"/>
    <dgm:cxn modelId="{F12E2781-5488-4C71-BAFA-E453CFE01CC4}" type="presOf" srcId="{3D684BC5-233D-4161-B95D-FA5611C99DE4}" destId="{3D8A67C0-0094-4D51-8735-3164E204BAD8}" srcOrd="0" destOrd="0" presId="urn:microsoft.com/office/officeart/2005/8/layout/process1"/>
    <dgm:cxn modelId="{26FE80C7-5AD3-4379-B38C-679118C8AA72}" type="presOf" srcId="{AD7E94FE-244E-4F5F-AC04-7A718F7F7555}" destId="{9063EC84-6E16-435E-A5B8-C2D105C2FC3A}" srcOrd="1" destOrd="0" presId="urn:microsoft.com/office/officeart/2005/8/layout/process1"/>
    <dgm:cxn modelId="{622888C7-CAEF-417C-BA99-931872A16C65}" srcId="{3D684BC5-233D-4161-B95D-FA5611C99DE4}" destId="{D4CE7497-4E12-4325-BFE2-8A66305BFBC9}" srcOrd="1" destOrd="0" parTransId="{71F3E36F-CA33-47AE-8034-B1E599091E87}" sibTransId="{B5E292BD-46DE-4F6A-AFE6-37E446E522A0}"/>
    <dgm:cxn modelId="{7A062DCE-26C9-4231-9688-AB4D7326A921}" type="presOf" srcId="{D4CE7497-4E12-4325-BFE2-8A66305BFBC9}" destId="{272AE1EA-5A95-4B6B-9952-6949F14CEBF6}" srcOrd="0" destOrd="0" presId="urn:microsoft.com/office/officeart/2005/8/layout/process1"/>
    <dgm:cxn modelId="{F84B57D9-F94A-485D-853B-5F5288307891}" srcId="{3D684BC5-233D-4161-B95D-FA5611C99DE4}" destId="{0280DF0E-B220-4B5A-9233-CC2638710A63}" srcOrd="0" destOrd="0" parTransId="{2E1C4EF7-ABA3-48F8-8C8E-387F163F12BC}" sibTransId="{AD7E94FE-244E-4F5F-AC04-7A718F7F7555}"/>
    <dgm:cxn modelId="{2528ABEB-7FC0-4730-89EB-5E3D37D9497D}" type="presOf" srcId="{0280DF0E-B220-4B5A-9233-CC2638710A63}" destId="{D33D3FEF-0987-406F-B91D-B0638669063A}" srcOrd="0" destOrd="0" presId="urn:microsoft.com/office/officeart/2005/8/layout/process1"/>
    <dgm:cxn modelId="{C6FDF5E1-E765-4862-A418-EF7D4415028E}" type="presParOf" srcId="{3D8A67C0-0094-4D51-8735-3164E204BAD8}" destId="{D33D3FEF-0987-406F-B91D-B0638669063A}" srcOrd="0" destOrd="0" presId="urn:microsoft.com/office/officeart/2005/8/layout/process1"/>
    <dgm:cxn modelId="{0BB6C2A0-43CA-4261-AF48-18C77345129F}" type="presParOf" srcId="{3D8A67C0-0094-4D51-8735-3164E204BAD8}" destId="{290DF2AB-6BF9-4742-8DAA-B5DE618875FA}" srcOrd="1" destOrd="0" presId="urn:microsoft.com/office/officeart/2005/8/layout/process1"/>
    <dgm:cxn modelId="{0B7704A1-2D7D-4949-AA0A-115D0D7AF0A0}" type="presParOf" srcId="{290DF2AB-6BF9-4742-8DAA-B5DE618875FA}" destId="{9063EC84-6E16-435E-A5B8-C2D105C2FC3A}" srcOrd="0" destOrd="0" presId="urn:microsoft.com/office/officeart/2005/8/layout/process1"/>
    <dgm:cxn modelId="{2052BFE9-E5B7-4F71-A71B-EC7B63688786}" type="presParOf" srcId="{3D8A67C0-0094-4D51-8735-3164E204BAD8}" destId="{272AE1EA-5A95-4B6B-9952-6949F14CEBF6}" srcOrd="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29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4A31D34-42A7-4631-B561-0F4EF5E50D5C}">
      <dsp:nvSpPr>
        <dsp:cNvPr id="0" name=""/>
        <dsp:cNvSpPr/>
      </dsp:nvSpPr>
      <dsp:spPr>
        <a:xfrm>
          <a:off x="2063448" y="388964"/>
          <a:ext cx="2223227" cy="223163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1600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600" kern="1200" dirty="0"/>
            <a:t>EAT </a:t>
          </a:r>
          <a:r>
            <a:rPr lang="de-DE" sz="3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600" kern="1200" dirty="0"/>
        </a:p>
      </dsp:txBody>
      <dsp:txXfrm>
        <a:off x="2389032" y="715780"/>
        <a:ext cx="1572059" cy="1578007"/>
      </dsp:txXfrm>
    </dsp:sp>
    <dsp:sp modelId="{72D9C816-81FB-497A-95CB-D00700E5EB82}">
      <dsp:nvSpPr>
        <dsp:cNvPr id="0" name=""/>
        <dsp:cNvSpPr/>
      </dsp:nvSpPr>
      <dsp:spPr>
        <a:xfrm rot="9076708">
          <a:off x="669032" y="2201099"/>
          <a:ext cx="1541225" cy="448923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FEDEC01-4661-4AE5-AE3C-CC7D19EF12D2}">
      <dsp:nvSpPr>
        <dsp:cNvPr id="0" name=""/>
        <dsp:cNvSpPr/>
      </dsp:nvSpPr>
      <dsp:spPr>
        <a:xfrm>
          <a:off x="114045" y="2453876"/>
          <a:ext cx="1310109" cy="73861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400" kern="1200" dirty="0"/>
            <a:t>LDL </a:t>
          </a:r>
          <a:r>
            <a:rPr lang="de-DE" sz="24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900" kern="1200" dirty="0"/>
            <a:t>β=0.008 mm per mg/dl</a:t>
          </a:r>
          <a:endParaRPr lang="de-DE" sz="900" kern="1200" dirty="0"/>
        </a:p>
      </dsp:txBody>
      <dsp:txXfrm>
        <a:off x="135678" y="2475509"/>
        <a:ext cx="1266843" cy="695351"/>
      </dsp:txXfrm>
    </dsp:sp>
    <dsp:sp modelId="{0DE0D7A6-BAB8-4F12-B563-772A2CCA5886}">
      <dsp:nvSpPr>
        <dsp:cNvPr id="0" name=""/>
        <dsp:cNvSpPr/>
      </dsp:nvSpPr>
      <dsp:spPr>
        <a:xfrm rot="12402445">
          <a:off x="735283" y="417088"/>
          <a:ext cx="1447960" cy="448923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F235D20-8643-46B7-8769-4CAED7B2F582}">
      <dsp:nvSpPr>
        <dsp:cNvPr id="0" name=""/>
        <dsp:cNvSpPr/>
      </dsp:nvSpPr>
      <dsp:spPr>
        <a:xfrm>
          <a:off x="145384" y="-44802"/>
          <a:ext cx="1334276" cy="721941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400" kern="1200" dirty="0"/>
            <a:t>Age </a:t>
          </a:r>
          <a:r>
            <a:rPr lang="de-DE" sz="24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900" kern="1200" dirty="0"/>
            <a:t>β=0.038 mm per year</a:t>
          </a:r>
          <a:endParaRPr lang="de-DE" sz="900" kern="1200" dirty="0"/>
        </a:p>
      </dsp:txBody>
      <dsp:txXfrm>
        <a:off x="166529" y="-23657"/>
        <a:ext cx="1291986" cy="679651"/>
      </dsp:txXfrm>
    </dsp:sp>
    <dsp:sp modelId="{38267C99-D6DB-41E7-84D1-CC9D0A9E3C4F}">
      <dsp:nvSpPr>
        <dsp:cNvPr id="0" name=""/>
        <dsp:cNvSpPr/>
      </dsp:nvSpPr>
      <dsp:spPr>
        <a:xfrm rot="10723485">
          <a:off x="780660" y="1320127"/>
          <a:ext cx="1212651" cy="448923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713D318-9C9D-4D8F-B585-C60DBED0CB92}">
      <dsp:nvSpPr>
        <dsp:cNvPr id="0" name=""/>
        <dsp:cNvSpPr/>
      </dsp:nvSpPr>
      <dsp:spPr>
        <a:xfrm>
          <a:off x="108442" y="1197166"/>
          <a:ext cx="1344736" cy="72183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400" kern="1200" dirty="0"/>
            <a:t>BMI </a:t>
          </a:r>
          <a:r>
            <a:rPr lang="de-DE" sz="24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</a:p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900" kern="1200" dirty="0"/>
            <a:t>β=0.097 mm per kg/m²</a:t>
          </a:r>
          <a:endParaRPr lang="de-DE" sz="900" kern="1200" dirty="0"/>
        </a:p>
      </dsp:txBody>
      <dsp:txXfrm>
        <a:off x="129584" y="1218308"/>
        <a:ext cx="1302452" cy="679549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957A74D-0222-4B57-89DB-44E6B83AA236}">
      <dsp:nvSpPr>
        <dsp:cNvPr id="0" name=""/>
        <dsp:cNvSpPr/>
      </dsp:nvSpPr>
      <dsp:spPr>
        <a:xfrm>
          <a:off x="97013" y="660496"/>
          <a:ext cx="2249691" cy="2211111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1600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600" kern="1200" dirty="0"/>
            <a:t>EAT </a:t>
          </a:r>
          <a:r>
            <a:rPr lang="de-DE" sz="3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600" kern="1200" dirty="0"/>
        </a:p>
      </dsp:txBody>
      <dsp:txXfrm>
        <a:off x="426473" y="984306"/>
        <a:ext cx="1590771" cy="1563491"/>
      </dsp:txXfrm>
    </dsp:sp>
    <dsp:sp modelId="{367F8417-8DA6-4EC4-AB39-A39F2927630E}">
      <dsp:nvSpPr>
        <dsp:cNvPr id="0" name=""/>
        <dsp:cNvSpPr/>
      </dsp:nvSpPr>
      <dsp:spPr>
        <a:xfrm rot="8891">
          <a:off x="2590602" y="1407111"/>
          <a:ext cx="517075" cy="726298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3100" kern="1200"/>
        </a:p>
      </dsp:txBody>
      <dsp:txXfrm>
        <a:off x="2590602" y="1552170"/>
        <a:ext cx="361953" cy="435778"/>
      </dsp:txXfrm>
    </dsp:sp>
    <dsp:sp modelId="{CE7CFA3A-FD89-4FD7-A4F5-AA052CA32FE9}">
      <dsp:nvSpPr>
        <dsp:cNvPr id="0" name=""/>
        <dsp:cNvSpPr/>
      </dsp:nvSpPr>
      <dsp:spPr>
        <a:xfrm>
          <a:off x="3322307" y="630731"/>
          <a:ext cx="2306311" cy="2287470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0640" tIns="40640" rIns="40640" bIns="4064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200" kern="1200" dirty="0"/>
            <a:t>LVH </a:t>
          </a:r>
          <a:r>
            <a:rPr lang="de-DE" sz="32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3200" kern="1200" dirty="0"/>
        </a:p>
      </dsp:txBody>
      <dsp:txXfrm>
        <a:off x="3660058" y="965723"/>
        <a:ext cx="1630809" cy="1617486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8E5ED40-4DDA-44AA-BB5E-4E23AC427B61}">
      <dsp:nvSpPr>
        <dsp:cNvPr id="0" name=""/>
        <dsp:cNvSpPr/>
      </dsp:nvSpPr>
      <dsp:spPr>
        <a:xfrm>
          <a:off x="1430" y="0"/>
          <a:ext cx="3050946" cy="1083951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800" kern="1200" dirty="0"/>
            <a:t>988 </a:t>
          </a:r>
          <a:r>
            <a:rPr lang="de-DE" sz="1800" kern="1200" dirty="0" err="1"/>
            <a:t>Probands</a:t>
          </a:r>
          <a:r>
            <a:rPr lang="de-DE" sz="1800" kern="1200" dirty="0"/>
            <a:t> </a:t>
          </a:r>
          <a:r>
            <a:rPr lang="de-DE" sz="1800" kern="1200" dirty="0" err="1"/>
            <a:t>from</a:t>
          </a:r>
          <a:r>
            <a:rPr lang="de-DE" sz="1800" kern="1200" dirty="0"/>
            <a:t> </a:t>
          </a:r>
          <a:r>
            <a:rPr lang="de-DE" sz="1800" kern="1200" dirty="0" err="1"/>
            <a:t>the</a:t>
          </a:r>
          <a:r>
            <a:rPr lang="de-DE" sz="1800" kern="1200" dirty="0"/>
            <a:t> </a:t>
          </a:r>
          <a:r>
            <a:rPr lang="de-DE" sz="1800" kern="1200" dirty="0" err="1"/>
            <a:t>AugUR</a:t>
          </a:r>
          <a:r>
            <a:rPr lang="de-DE" sz="1800" kern="1200" dirty="0"/>
            <a:t>-Trial </a:t>
          </a:r>
        </a:p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800" kern="1200" dirty="0"/>
            <a:t>(</a:t>
          </a:r>
          <a:r>
            <a:rPr lang="de-DE" sz="1800" kern="1200" dirty="0" err="1"/>
            <a:t>aged</a:t>
          </a:r>
          <a:r>
            <a:rPr lang="de-DE" sz="1800" kern="1200" dirty="0"/>
            <a:t> 70-94)</a:t>
          </a:r>
        </a:p>
      </dsp:txBody>
      <dsp:txXfrm>
        <a:off x="33178" y="31748"/>
        <a:ext cx="2987450" cy="1020455"/>
      </dsp:txXfrm>
    </dsp:sp>
    <dsp:sp modelId="{8EFADDA9-AED5-4583-AF4F-1D94266F80FC}">
      <dsp:nvSpPr>
        <dsp:cNvPr id="0" name=""/>
        <dsp:cNvSpPr/>
      </dsp:nvSpPr>
      <dsp:spPr>
        <a:xfrm>
          <a:off x="3357471" y="163658"/>
          <a:ext cx="646800" cy="756634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400" kern="1200"/>
        </a:p>
      </dsp:txBody>
      <dsp:txXfrm>
        <a:off x="3357471" y="314985"/>
        <a:ext cx="452760" cy="453980"/>
      </dsp:txXfrm>
    </dsp:sp>
    <dsp:sp modelId="{12B1C446-D8F9-42E3-8066-676E3EFDF7AC}">
      <dsp:nvSpPr>
        <dsp:cNvPr id="0" name=""/>
        <dsp:cNvSpPr/>
      </dsp:nvSpPr>
      <dsp:spPr>
        <a:xfrm>
          <a:off x="4272755" y="0"/>
          <a:ext cx="3050946" cy="1083951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800" kern="1200" dirty="0"/>
            <a:t>EAT + LV </a:t>
          </a:r>
          <a:r>
            <a:rPr lang="de-DE" sz="1800" kern="1200" dirty="0" err="1"/>
            <a:t>geometry</a:t>
          </a:r>
          <a:r>
            <a:rPr lang="de-DE" sz="1800" kern="1200" dirty="0"/>
            <a:t> </a:t>
          </a:r>
          <a:r>
            <a:rPr lang="de-DE" sz="1800" kern="1200" dirty="0" err="1"/>
            <a:t>measured</a:t>
          </a:r>
          <a:r>
            <a:rPr lang="de-DE" sz="1800" kern="1200" dirty="0"/>
            <a:t> via </a:t>
          </a:r>
          <a:r>
            <a:rPr lang="de-DE" sz="1800" kern="1200" dirty="0" err="1"/>
            <a:t>echocardiography</a:t>
          </a:r>
          <a:endParaRPr lang="de-DE" sz="1800" kern="1200" dirty="0"/>
        </a:p>
      </dsp:txBody>
      <dsp:txXfrm>
        <a:off x="4304503" y="31748"/>
        <a:ext cx="2987450" cy="1020455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33D3FEF-0987-406F-B91D-B0638669063A}">
      <dsp:nvSpPr>
        <dsp:cNvPr id="0" name=""/>
        <dsp:cNvSpPr/>
      </dsp:nvSpPr>
      <dsp:spPr>
        <a:xfrm>
          <a:off x="971" y="0"/>
          <a:ext cx="2072568" cy="6036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060" tIns="99060" rIns="99060" bIns="9906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600" kern="1200" dirty="0"/>
            <a:t>Age </a:t>
          </a:r>
          <a:r>
            <a:rPr lang="de-DE" sz="2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2600" kern="1200" dirty="0"/>
        </a:p>
      </dsp:txBody>
      <dsp:txXfrm>
        <a:off x="18652" y="17681"/>
        <a:ext cx="2037206" cy="568325"/>
      </dsp:txXfrm>
    </dsp:sp>
    <dsp:sp modelId="{290DF2AB-6BF9-4742-8DAA-B5DE618875FA}">
      <dsp:nvSpPr>
        <dsp:cNvPr id="0" name=""/>
        <dsp:cNvSpPr/>
      </dsp:nvSpPr>
      <dsp:spPr>
        <a:xfrm>
          <a:off x="2280797" y="44844"/>
          <a:ext cx="439384" cy="513997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2100" kern="1200"/>
        </a:p>
      </dsp:txBody>
      <dsp:txXfrm>
        <a:off x="2280797" y="147643"/>
        <a:ext cx="307569" cy="308399"/>
      </dsp:txXfrm>
    </dsp:sp>
    <dsp:sp modelId="{272AE1EA-5A95-4B6B-9952-6949F14CEBF6}">
      <dsp:nvSpPr>
        <dsp:cNvPr id="0" name=""/>
        <dsp:cNvSpPr/>
      </dsp:nvSpPr>
      <dsp:spPr>
        <a:xfrm>
          <a:off x="2902568" y="0"/>
          <a:ext cx="2072568" cy="6036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060" tIns="99060" rIns="99060" bIns="9906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600" kern="1200" dirty="0"/>
            <a:t>EAT </a:t>
          </a:r>
          <a:r>
            <a:rPr lang="de-DE" sz="2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2600" kern="1200" dirty="0"/>
        </a:p>
      </dsp:txBody>
      <dsp:txXfrm>
        <a:off x="2920249" y="17681"/>
        <a:ext cx="2037206" cy="568325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33D3FEF-0987-406F-B91D-B0638669063A}">
      <dsp:nvSpPr>
        <dsp:cNvPr id="0" name=""/>
        <dsp:cNvSpPr/>
      </dsp:nvSpPr>
      <dsp:spPr>
        <a:xfrm>
          <a:off x="971" y="0"/>
          <a:ext cx="2072568" cy="6036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060" tIns="99060" rIns="99060" bIns="9906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600" kern="1200" dirty="0"/>
            <a:t>EAT</a:t>
          </a:r>
          <a:r>
            <a:rPr lang="de-DE" sz="2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2600" kern="1200" dirty="0"/>
        </a:p>
      </dsp:txBody>
      <dsp:txXfrm>
        <a:off x="18652" y="17681"/>
        <a:ext cx="2037206" cy="568325"/>
      </dsp:txXfrm>
    </dsp:sp>
    <dsp:sp modelId="{290DF2AB-6BF9-4742-8DAA-B5DE618875FA}">
      <dsp:nvSpPr>
        <dsp:cNvPr id="0" name=""/>
        <dsp:cNvSpPr/>
      </dsp:nvSpPr>
      <dsp:spPr>
        <a:xfrm>
          <a:off x="2280797" y="44844"/>
          <a:ext cx="439384" cy="513997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2100" kern="1200"/>
        </a:p>
      </dsp:txBody>
      <dsp:txXfrm>
        <a:off x="2280797" y="147643"/>
        <a:ext cx="307569" cy="308399"/>
      </dsp:txXfrm>
    </dsp:sp>
    <dsp:sp modelId="{272AE1EA-5A95-4B6B-9952-6949F14CEBF6}">
      <dsp:nvSpPr>
        <dsp:cNvPr id="0" name=""/>
        <dsp:cNvSpPr/>
      </dsp:nvSpPr>
      <dsp:spPr>
        <a:xfrm>
          <a:off x="2902568" y="0"/>
          <a:ext cx="2072568" cy="603687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060" tIns="99060" rIns="99060" bIns="9906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600" kern="1200" dirty="0"/>
            <a:t>LVM</a:t>
          </a:r>
          <a:r>
            <a:rPr lang="de-DE" sz="260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↑</a:t>
          </a:r>
          <a:endParaRPr lang="de-DE" sz="2600" kern="1200" dirty="0"/>
        </a:p>
      </dsp:txBody>
      <dsp:txXfrm>
        <a:off x="2920249" y="17681"/>
        <a:ext cx="2037206" cy="56832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4">
  <dgm:title val=""/>
  <dgm:desc val=""/>
  <dgm:catLst>
    <dgm:cat type="relationship" pri="1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5" srcId="1" destId="11" srcOrd="0" destOrd="0"/>
        <dgm:cxn modelId="16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ycle">
    <dgm:varLst>
      <dgm:chMax val="1"/>
      <dgm:dir/>
      <dgm:animLvl val="ctr"/>
      <dgm:resizeHandles val="exact"/>
    </dgm:varLst>
    <dgm:choose name="Name0">
      <dgm:if name="Name1" func="var" arg="dir" op="equ" val="norm">
        <dgm:choose name="Name2">
          <dgm:if name="Name3" axis="ch ch" ptType="node node" st="1 1" cnt="1 0" func="cnt" op="lte" val="1">
            <dgm:alg type="cycle">
              <dgm:param type="stAng" val="0"/>
              <dgm:param type="spanAng" val="360"/>
              <dgm:param type="ctrShpMap" val="fNode"/>
            </dgm:alg>
          </dgm:if>
          <dgm:else name="Name4">
            <dgm:choose name="Name5">
              <dgm:if name="Name6" axis="ch ch" ptType="node node" st="1 1" cnt="1 0" func="cnt" op="lte" val="3">
                <dgm:alg type="cycle">
                  <dgm:param type="stAng" val="-55"/>
                  <dgm:param type="spanAng" val="110"/>
                  <dgm:param type="ctrShpMap" val="fNode"/>
                </dgm:alg>
              </dgm:if>
              <dgm:else name="Name7">
                <dgm:choose name="Name8">
                  <dgm:if name="Name9" axis="ch ch" ptType="node node" st="1 1" cnt="1 0" func="cnt" op="equ" val="4">
                    <dgm:alg type="cycle">
                      <dgm:param type="stAng" val="-75"/>
                      <dgm:param type="spanAng" val="150"/>
                      <dgm:param type="ctrShpMap" val="fNode"/>
                    </dgm:alg>
                  </dgm:if>
                  <dgm:else name="Name10">
                    <dgm:alg type="cycle">
                      <dgm:param type="stAng" val="-90"/>
                      <dgm:param type="spanAng" val="180"/>
                      <dgm:param type="ctrShpMap" val="fNode"/>
                    </dgm:alg>
                  </dgm:else>
                </dgm:choose>
              </dgm:else>
            </dgm:choose>
          </dgm:else>
        </dgm:choose>
      </dgm:if>
      <dgm:else name="Name11">
        <dgm:choose name="Name12">
          <dgm:if name="Name13" axis="ch ch" ptType="node node" st="1 1" cnt="1 0" func="cnt" op="lte" val="1">
            <dgm:alg type="cycle">
              <dgm:param type="stAng" val="0"/>
              <dgm:param type="spanAng" val="-360"/>
              <dgm:param type="ctrShpMap" val="fNode"/>
            </dgm:alg>
          </dgm:if>
          <dgm:else name="Name14">
            <dgm:choose name="Name15">
              <dgm:if name="Name16" axis="ch ch" ptType="node node" st="1 1" cnt="1 0" func="cnt" op="lte" val="3">
                <dgm:alg type="cycle">
                  <dgm:param type="stAng" val="55"/>
                  <dgm:param type="spanAng" val="-110"/>
                  <dgm:param type="ctrShpMap" val="fNode"/>
                </dgm:alg>
              </dgm:if>
              <dgm:else name="Name17">
                <dgm:choose name="Name18">
                  <dgm:if name="Name19" axis="ch ch" ptType="node node" st="1 1" cnt="1 0" func="cnt" op="equ" val="4">
                    <dgm:alg type="cycle">
                      <dgm:param type="stAng" val="75"/>
                      <dgm:param type="spanAng" val="-150"/>
                      <dgm:param type="ctrShpMap" val="fNode"/>
                    </dgm:alg>
                  </dgm:if>
                  <dgm:else name="Name20">
                    <dgm:alg type="cycle">
                      <dgm:param type="stAng" val="90"/>
                      <dgm:param type="spanAng" val="-180"/>
                      <dgm:param type="ctrShpMap" val="fNode"/>
                    </dgm:alg>
                  </dgm:else>
                </dgm:choose>
              </dgm:else>
            </dgm:choose>
          </dgm:else>
        </dgm:choose>
      </dgm:else>
    </dgm:choose>
    <dgm:shape xmlns:r="http://schemas.openxmlformats.org/officeDocument/2006/relationships" r:blip="">
      <dgm:adjLst/>
    </dgm:shape>
    <dgm:presOf/>
    <dgm:constrLst>
      <dgm:constr type="w" for="ch" forName="centerShape" refType="w"/>
      <dgm:constr type="w" for="ch" forName="node" refType="w" refFor="ch" refForName="centerShape" fact="0.95"/>
      <dgm:constr type="h" for="ch" forName="parTrans" refType="w" refFor="ch" refForName="centerShape" fact="0.285"/>
      <dgm:constr type="sp" refType="w" refFor="ch" refForName="centerShape" op="equ" fact="0.23"/>
      <dgm:constr type="sibSp" refType="w" refFor="ch" refForName="node" fact="0.1"/>
      <dgm:constr type="primFontSz" for="ch" forName="node" op="equ"/>
    </dgm:constrLst>
    <dgm:choose name="Name21">
      <dgm:if name="Name22" axis="ch ch" ptType="node node" st="1 1" cnt="1 0" func="cnt" op="lte" val="5">
        <dgm:ruleLst>
          <dgm:rule type="w" for="ch" forName="centerShape" val="NaN" fact="0.27" max="NaN"/>
        </dgm:ruleLst>
      </dgm:if>
      <dgm:else name="Name23">
        <dgm:ruleLst>
          <dgm:rule type="w" for="ch" forName="centerShape" val="NaN" fact="0.27" max="NaN"/>
          <dgm:rule type="w" for="ch" forName="node" val="NaN" fact="0.7" max="NaN"/>
        </dgm:ruleLst>
      </dgm:else>
    </dgm:choose>
    <dgm:forEach name="Name24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tMarg" refType="primFontSz" fact="0.05"/>
          <dgm:constr type="bMarg" refType="primFontSz" fact="0.05"/>
          <dgm:constr type="lMarg" refType="primFontSz" fact="0.05"/>
          <dgm:constr type="rMarg" refType="primFontSz" fact="0.05"/>
          <dgm:constr type="primFontSz" val="65"/>
          <dgm:constr type="h" refType="w"/>
        </dgm:constrLst>
        <dgm:ruleLst>
          <dgm:rule type="primFontSz" val="5" fact="NaN" max="NaN"/>
        </dgm:ruleLst>
      </dgm:layoutNode>
      <dgm:forEach name="Name25" axis="ch">
        <dgm:forEach name="Name26" axis="self" ptType="parTrans">
          <dgm:layoutNode name="parTrans" styleLbl="bgSibTrans2D1">
            <dgm:alg type="conn">
              <dgm:param type="begPts" val="auto"/>
              <dgm:param type="endPts" val="ctr"/>
              <dgm:param type="endSty" val="noArr"/>
              <dgm:param type="begSty" val="arr"/>
            </dgm:alg>
            <dgm:shape xmlns:r="http://schemas.openxmlformats.org/officeDocument/2006/relationships" type="conn" r:blip="">
              <dgm:adjLst/>
            </dgm:shape>
            <dgm:presOf axis="self"/>
            <dgm:constrLst>
              <dgm:constr type="begPad" refType="connDist" fact="0.055"/>
              <dgm:constr type="endPad"/>
            </dgm:constrLst>
            <dgm:ruleLst/>
          </dgm:layoutNode>
        </dgm:forEach>
        <dgm:forEach name="Name27" axis="self" ptType="node">
          <dgm:layoutNode name="node" styleLbl="node1">
            <dgm:varLst>
              <dgm:bulletEnabled val="1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OrSelf" ptType="node"/>
            <dgm:constrLst>
              <dgm:constr type="primFontSz" val="65"/>
              <dgm:constr type="h" refType="w" fact="0.8"/>
              <dgm:constr type="tMarg" refType="primFontSz" fact="0.15"/>
              <dgm:constr type="bMarg" refType="primFontSz" fact="0.15"/>
              <dgm:constr type="lMarg" refType="primFontSz" fact="0.15"/>
              <dgm:constr type="rMarg" refType="primFontSz" fact="0.15"/>
            </dgm:constrLst>
            <dgm:ruleLst>
              <dgm:rule type="primFontSz" val="5" fact="NaN" max="NaN"/>
            </dgm:ruleLst>
          </dgm:layoutNode>
        </dgm:forEach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equation2">
  <dgm:title val=""/>
  <dgm:desc val=""/>
  <dgm:catLst>
    <dgm:cat type="relationship" pri="18000"/>
    <dgm:cat type="process" pri="26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>
          <dgm:param type="linDir" val="fromL"/>
          <dgm:param type="fallback" val="2D"/>
        </dgm:alg>
      </dgm:if>
      <dgm:else name="Name3">
        <dgm:alg type="lin">
          <dgm:param type="linDir" val="fromR"/>
          <dgm:param type="fallback" val="2D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ch" ptType="node" func="cnt" op="gte" val="3">
        <dgm:constrLst>
          <dgm:constr type="h" for="des" forName="node" refType="w" fact="0.5"/>
          <dgm:constr type="w" for="ch" forName="lastNode" refType="w"/>
          <dgm:constr type="w" for="des" forName="node" refType="h" refFor="des" refForName="node"/>
          <dgm:constr type="w" for="ch" forName="sibTransLast" refType="h" refFor="des" refForName="node" fact="0.6"/>
          <dgm:constr type="h" for="des" forName="sibTrans" refType="h" refFor="des" refForName="node" op="equ" fact="0.58"/>
          <dgm:constr type="w" for="des" forName="sibTrans" refType="h" refFor="des" refForName="sibTrans" op="equ"/>
          <dgm:constr type="primFontSz" for="ch" forName="lastNode" op="equ" val="65"/>
          <dgm:constr type="primFontSz" for="des" forName="node" op="equ" val="65"/>
          <dgm:constr type="primFontSz" for="des" forName="sibTrans" val="55"/>
          <dgm:constr type="primFontSz" for="des" forName="sibTrans" refType="primFontSz" refFor="des" refForName="node" op="lte" fact="0.8"/>
          <dgm:constr type="primFontSz" for="des" forName="connectorText" refType="primFontSz" refFor="des" refForName="node" op="lte" fact="0.8"/>
          <dgm:constr type="primFontSz" for="des" forName="connectorText" refType="primFontSz" refFor="des" refForName="sibTrans" op="equ"/>
          <dgm:constr type="h" for="des" forName="spacerT" refType="h" refFor="des" refForName="sibTrans" fact="0.14"/>
          <dgm:constr type="h" for="des" forName="spacerB" refType="h" refFor="des" refForName="sibTrans" fact="0.14"/>
        </dgm:constrLst>
      </dgm:if>
      <dgm:else name="Name6">
        <dgm:constrLst>
          <dgm:constr type="h" for="des" forName="node" refType="w"/>
          <dgm:constr type="w" for="ch" forName="lastNode" refType="w"/>
          <dgm:constr type="w" for="des" forName="node" refType="h" refFor="des" refForName="node"/>
          <dgm:constr type="w" for="ch" forName="sibTransLast" refType="h" refFor="des" refForName="node" fact="0.6"/>
          <dgm:constr type="h" for="des" forName="sibTrans" refType="h" refFor="des" refForName="node" op="equ" fact="0.58"/>
          <dgm:constr type="w" for="des" forName="sibTrans" refType="h" refFor="des" refForName="sibTrans" op="equ"/>
          <dgm:constr type="primFontSz" for="des" forName="node" val="65"/>
          <dgm:constr type="primFontSz" for="ch" forName="lastNode" refType="primFontSz" refFor="des" refForName="node" op="equ"/>
          <dgm:constr type="primFontSz" for="des" forName="sibTrans" val="55"/>
          <dgm:constr type="primFontSz" for="des" forName="connectorText" refType="primFontSz" refFor="des" refForName="node" op="lte" fact="0.8"/>
          <dgm:constr type="primFontSz" for="des" forName="connectorText" refType="primFontSz" refFor="des" refForName="sibTrans" op="equ"/>
          <dgm:constr type="h" for="des" forName="spacerT" refType="h" refFor="des" refForName="sibTrans" fact="0.14"/>
          <dgm:constr type="h" for="des" forName="spacerB" refType="h" refFor="des" refForName="sibTrans" fact="0.14"/>
        </dgm:constrLst>
      </dgm:else>
    </dgm:choose>
    <dgm:ruleLst/>
    <dgm:choose name="Name7">
      <dgm:if name="Name8" axis="ch" ptType="node" func="cnt" op="gte" val="1">
        <dgm:layoutNode name="vNodes">
          <dgm:alg type="lin">
            <dgm:param type="linDir" val="fromT"/>
            <dgm:param type="fallback" val="2D"/>
          </dgm:alg>
          <dgm:shape xmlns:r="http://schemas.openxmlformats.org/officeDocument/2006/relationships" r:blip="">
            <dgm:adjLst/>
          </dgm:shape>
          <dgm:presOf/>
          <dgm:constrLst/>
          <dgm:ruleLst/>
          <dgm:forEach name="Name9" axis="ch" ptType="node">
            <dgm:choose name="Name10">
              <dgm:if name="Name11" axis="self" func="revPos" op="neq" val="1">
                <dgm:layoutNode name="node">
                  <dgm:varLst>
                    <dgm:bulletEnabled val="1"/>
                  </dgm:varLst>
                  <dgm:alg type="tx">
                    <dgm:param type="txAnchorVertCh" val="mid"/>
                  </dgm:alg>
                  <dgm:shape xmlns:r="http://schemas.openxmlformats.org/officeDocument/2006/relationships" type="ellipse" r:blip="">
                    <dgm:adjLst/>
                  </dgm:shape>
                  <dgm:presOf axis="desOrSelf" ptType="node"/>
                  <dgm:constrLst>
                    <dgm:constr type="tMarg" refType="primFontSz" fact="0.1"/>
                    <dgm:constr type="bMarg" refType="primFontSz" fact="0.1"/>
                    <dgm:constr type="lMarg" refType="primFontSz" fact="0.1"/>
                    <dgm:constr type="rMarg" refType="primFontSz" fact="0.1"/>
                  </dgm:constrLst>
                  <dgm:ruleLst>
                    <dgm:rule type="primFontSz" val="5" fact="NaN" max="NaN"/>
                  </dgm:ruleLst>
                </dgm:layoutNode>
                <dgm:choose name="Name12">
                  <dgm:if name="Name13" axis="self" ptType="node" func="revPos" op="gt" val="2">
                    <dgm:forEach name="sibTransForEach" axis="followSib" ptType="sibTrans" cnt="1">
                      <dgm:layoutNode name="spacerT">
                        <dgm:alg type="sp"/>
                        <dgm:shape xmlns:r="http://schemas.openxmlformats.org/officeDocument/2006/relationships" r:blip="">
                          <dgm:adjLst/>
                        </dgm:shape>
                        <dgm:presOf axis="self"/>
                        <dgm:constrLst/>
                        <dgm:ruleLst/>
                      </dgm:layoutNode>
                      <dgm:layoutNode name="sibTrans">
                        <dgm:alg type="tx"/>
                        <dgm:shape xmlns:r="http://schemas.openxmlformats.org/officeDocument/2006/relationships" type="mathPlus" r:blip="">
                          <dgm:adjLst/>
                        </dgm:shape>
                        <dgm:presOf axis="self"/>
                        <dgm:constrLst>
                          <dgm:constr type="h" refType="w"/>
                          <dgm:constr type="lMarg"/>
                          <dgm:constr type="rMarg"/>
                          <dgm:constr type="tMarg"/>
                          <dgm:constr type="bMarg"/>
                        </dgm:constrLst>
                        <dgm:ruleLst>
                          <dgm:rule type="primFontSz" val="5" fact="NaN" max="NaN"/>
                        </dgm:ruleLst>
                      </dgm:layoutNode>
                      <dgm:layoutNode name="spacerB">
                        <dgm:alg type="sp"/>
                        <dgm:shape xmlns:r="http://schemas.openxmlformats.org/officeDocument/2006/relationships" r:blip="">
                          <dgm:adjLst/>
                        </dgm:shape>
                        <dgm:presOf axis="self"/>
                        <dgm:constrLst/>
                        <dgm:ruleLst/>
                      </dgm:layoutNode>
                    </dgm:forEach>
                  </dgm:if>
                  <dgm:else name="Name14"/>
                </dgm:choose>
              </dgm:if>
              <dgm:else name="Name15"/>
            </dgm:choose>
          </dgm:forEach>
        </dgm:layoutNode>
        <dgm:choose name="Name16">
          <dgm:if name="Name17" axis="ch" ptType="node" func="cnt" op="gt" val="1">
            <dgm:layoutNode name="sibTransLast">
              <dgm:alg type="conn">
                <dgm:param type="begPts" val="auto"/>
                <dgm:param type="endPts" val="auto"/>
                <dgm:param type="srcNode" val="vNodes"/>
                <dgm:param type="dstNode" val="lastNode"/>
              </dgm:alg>
              <dgm:shape xmlns:r="http://schemas.openxmlformats.org/officeDocument/2006/relationships" type="conn" r:blip="">
                <dgm:adjLst/>
              </dgm:shape>
              <dgm:presOf axis="ch" ptType="sibTrans" st="-1" cnt="1"/>
              <dgm:constrLst>
                <dgm:constr type="h" refType="w" fact="0.62"/>
                <dgm:constr type="connDist"/>
                <dgm:constr type="begPad" refType="connDist" fact="0.25"/>
                <dgm:constr type="endPad" refType="connDist" fact="0.22"/>
              </dgm:constrLst>
              <dgm:ruleLst/>
              <dgm:layoutNode name="connectorText">
                <dgm:alg type="tx">
                  <dgm:param type="autoTxRot" val="grav"/>
                </dgm:alg>
                <dgm:shape xmlns:r="http://schemas.openxmlformats.org/officeDocument/2006/relationships" type="conn" r:blip="" hideGeom="1">
                  <dgm:adjLst/>
                </dgm:shape>
                <dgm:presOf axis="ch desOrSelf" ptType="sibTrans sibTrans" st="-1 1" cnt="1 0"/>
                <dgm:constrLst>
                  <dgm:constr type="lMarg"/>
                  <dgm:constr type="rMarg"/>
                  <dgm:constr type="tMarg"/>
                  <dgm:constr type="bMarg"/>
                </dgm:constrLst>
                <dgm:ruleLst>
                  <dgm:rule type="primFontSz" val="5" fact="NaN" max="NaN"/>
                </dgm:ruleLst>
              </dgm:layoutNode>
            </dgm:layoutNode>
          </dgm:if>
          <dgm:else name="Name18"/>
        </dgm:choose>
        <dgm:layoutNode name="lastNode">
          <dgm:varLst>
            <dgm:bulletEnabled val="1"/>
          </dgm:varLst>
          <dgm:alg type="tx">
            <dgm:param type="txAnchorVertCh" val="mid"/>
          </dgm:alg>
          <dgm:shape xmlns:r="http://schemas.openxmlformats.org/officeDocument/2006/relationships" type="ellipse" r:blip="">
            <dgm:adjLst/>
          </dgm:shape>
          <dgm:presOf axis="ch desOrSelf" ptType="node node" st="-1 1" cnt="1 0"/>
          <dgm:constrLst>
            <dgm:constr type="h" refType="w"/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</dgm:if>
      <dgm:else name="Name19"/>
    </dgm:choose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1053FC-58DC-47C2-ADEC-3A2DC6AE404F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7CC1BF-029A-49AC-8FDC-C5C706C7B6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1059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9BAA1E-9E48-80A2-29FC-3FEF360649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300C74C-0CDE-9410-79D0-8379244FD8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6A6207-1725-3C96-62F5-09F137710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0AD5522-0369-DB0C-9609-D033A5370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69BD83-CC11-CAE0-799E-286214C82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1447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C7CE8CB-F262-82F2-83B1-1C1C3E929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F3C36B8-3298-63E8-EB27-7D932055A2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5076332-C16D-C094-1297-4E2269726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CF64B48-B035-32B7-7EEE-A9109A446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D2BBE9B-CDD9-726F-418E-2C5E8C3CB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7564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B40F385-A97B-9C69-1E02-CA84C17C11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04BE210-8E8D-5346-E273-9AB9556269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55E4E4D-B2D2-19D8-E3E2-147D580C9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08E6699-39C6-41E1-E1C3-9AD6AA54B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C6EEDF-DA91-EBD4-BF63-82D645225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615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3D3987F-75CF-5EDC-0CA6-409BE40BD1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744ADFE-BF42-7753-0A66-FF23C6999E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C0E2F3-F671-F7F7-A80E-4EDDA99E1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33EF9D7-B357-86AA-F163-3A4496D3A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3DC383-68D7-61CC-62E2-E58973385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49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EE13C48-8E96-B9CD-9058-67AEB21F32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E1EDEAA-2087-1E55-FA59-402E5097A3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6A705C1-738D-1191-9297-1593237B2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9CE2BB-C9E5-FA03-80D1-56EB3899B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B00C5F0-A582-7334-3A39-CC62ACD19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9990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DE30B2-FE8A-485F-10C1-FFFD61178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CB693A0-85CB-5889-88FC-21FF1C9D01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3CE7DCE-7E12-A8EB-9DE9-821EAA5DC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332A9D7-1198-EEC1-1640-83B213E6D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927DF01-6852-846F-1A6D-2CD3DB75E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2472BF7-5F4B-0E03-FC0B-5342C9B08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199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57F9EE-5907-B6CA-5D46-1A334C7567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C3BCB0D-3820-0C95-3123-A78E9C0AA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44A8B0C-AEDE-1072-EE10-01D8E05380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C206F97-6F5D-4F3E-4374-3B38B621D5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7643943-23F6-8BF5-7FF1-0E27AC540A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6CA91B5-C03D-33EE-7764-4476F9E44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CB6FD21-F6CF-9AD9-30B9-19F286CDE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D43D1DC-DF0A-5D6E-C540-2B9902E91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7078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0E137E-2D78-A921-B2EC-45E12B5C66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22291A6-C0D4-4A34-F62A-F5DF250A5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A207F3F-32CF-CC00-466B-98B5EF4CA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A011701-64D0-C185-14D5-544BC899C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532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6EF21CB-B0C8-9D22-9BA6-2F1023C39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81881DA-08AD-BF37-EF68-8BBE39431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6ABDAE1-347D-1B39-D888-79E1B3DBF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927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64C000-229D-1502-8AE0-DD3AA6189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E8F46A2-D731-1CE6-8B39-2989DED4CE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661B5D5-885A-4108-0CF7-921172576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CCA1CCA-CE13-FC6D-C5E8-722F0AB54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186D40A-58F5-9971-1EB7-AEEA4C757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D403325-380A-AB88-5D06-7CE354217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6207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9748CC9-FDAE-E9D3-7BBB-4B7D9F178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5FF1632-CA22-D9BD-884E-9B339E4C10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7E723D1-430D-3745-E06A-21D10BC885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F040C6F-753F-F81D-5FBD-9BAACA12A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EC522B7-6448-FA2C-DFBD-D7C93D993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B047D22-D380-DF55-90BB-481D03193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965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15F42E9-F67F-8598-2AAD-C9D64168D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F76D2F-80AE-4BC0-50A4-741AB660FE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141E09-2B6D-FE4C-E54E-A440FB3158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B8F21-0B5F-4C4E-9CC2-CD9FD20CA654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2E795E-A35D-4E33-9DD1-8535CC4597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1D964F-1C16-6F2A-85A6-D20AA98F25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4E9DA-F494-4A23-93DD-075E625A17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9389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diagramLayout" Target="../diagrams/layout3.xml"/><Relationship Id="rId18" Type="http://schemas.openxmlformats.org/officeDocument/2006/relationships/image" Target="../media/image2.png"/><Relationship Id="rId26" Type="http://schemas.openxmlformats.org/officeDocument/2006/relationships/diagramLayout" Target="../diagrams/layout5.xml"/><Relationship Id="rId3" Type="http://schemas.openxmlformats.org/officeDocument/2006/relationships/diagramLayout" Target="../diagrams/layout1.xml"/><Relationship Id="rId21" Type="http://schemas.openxmlformats.org/officeDocument/2006/relationships/diagramLayout" Target="../diagrams/layout4.xml"/><Relationship Id="rId7" Type="http://schemas.openxmlformats.org/officeDocument/2006/relationships/diagramData" Target="../diagrams/data2.xml"/><Relationship Id="rId12" Type="http://schemas.openxmlformats.org/officeDocument/2006/relationships/diagramData" Target="../diagrams/data3.xml"/><Relationship Id="rId17" Type="http://schemas.openxmlformats.org/officeDocument/2006/relationships/image" Target="../media/image1.png"/><Relationship Id="rId25" Type="http://schemas.openxmlformats.org/officeDocument/2006/relationships/diagramData" Target="../diagrams/data5.xml"/><Relationship Id="rId2" Type="http://schemas.openxmlformats.org/officeDocument/2006/relationships/diagramData" Target="../diagrams/data1.xml"/><Relationship Id="rId16" Type="http://schemas.microsoft.com/office/2007/relationships/diagramDrawing" Target="../diagrams/drawing3.xml"/><Relationship Id="rId20" Type="http://schemas.openxmlformats.org/officeDocument/2006/relationships/diagramData" Target="../diagrams/data4.xml"/><Relationship Id="rId29" Type="http://schemas.microsoft.com/office/2007/relationships/diagramDrawing" Target="../diagrams/drawing5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24" Type="http://schemas.microsoft.com/office/2007/relationships/diagramDrawing" Target="../diagrams/drawing4.xml"/><Relationship Id="rId5" Type="http://schemas.openxmlformats.org/officeDocument/2006/relationships/diagramColors" Target="../diagrams/colors1.xml"/><Relationship Id="rId15" Type="http://schemas.openxmlformats.org/officeDocument/2006/relationships/diagramColors" Target="../diagrams/colors3.xml"/><Relationship Id="rId23" Type="http://schemas.openxmlformats.org/officeDocument/2006/relationships/diagramColors" Target="../diagrams/colors4.xml"/><Relationship Id="rId28" Type="http://schemas.openxmlformats.org/officeDocument/2006/relationships/diagramColors" Target="../diagrams/colors5.xml"/><Relationship Id="rId10" Type="http://schemas.openxmlformats.org/officeDocument/2006/relationships/diagramColors" Target="../diagrams/colors2.xml"/><Relationship Id="rId19" Type="http://schemas.openxmlformats.org/officeDocument/2006/relationships/image" Target="../media/image3.png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QuickStyle" Target="../diagrams/quickStyle3.xml"/><Relationship Id="rId22" Type="http://schemas.openxmlformats.org/officeDocument/2006/relationships/diagramQuickStyle" Target="../diagrams/quickStyle4.xml"/><Relationship Id="rId27" Type="http://schemas.openxmlformats.org/officeDocument/2006/relationships/diagramQuickStyle" Target="../diagrams/quickStyl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55C3CF-32DA-DED9-207F-7824E7F16A1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ED9742B6-B059-406E-928C-C0E06FD329C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12361488"/>
              </p:ext>
            </p:extLst>
          </p:nvPr>
        </p:nvGraphicFramePr>
        <p:xfrm>
          <a:off x="716547" y="3614899"/>
          <a:ext cx="5379453" cy="356701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FFC60456-2946-5C0A-6409-B2A06E10267F}"/>
              </a:ext>
            </a:extLst>
          </p:cNvPr>
          <p:cNvGraphicFramePr/>
          <p:nvPr/>
        </p:nvGraphicFramePr>
        <p:xfrm>
          <a:off x="5398530" y="3411219"/>
          <a:ext cx="5728580" cy="356701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C5CAC4CA-759D-B6A3-3418-48B553467390}"/>
              </a:ext>
            </a:extLst>
          </p:cNvPr>
          <p:cNvSpPr txBox="1"/>
          <p:nvPr/>
        </p:nvSpPr>
        <p:spPr>
          <a:xfrm>
            <a:off x="7754284" y="4420975"/>
            <a:ext cx="976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men</a:t>
            </a:r>
          </a:p>
        </p:txBody>
      </p:sp>
      <p:graphicFrame>
        <p:nvGraphicFramePr>
          <p:cNvPr id="7" name="Diagramm 6">
            <a:extLst>
              <a:ext uri="{FF2B5EF4-FFF2-40B4-BE49-F238E27FC236}">
                <a16:creationId xmlns:a16="http://schemas.microsoft.com/office/drawing/2014/main" id="{340F415D-BA6C-67C4-3279-2F4F13BE8E99}"/>
              </a:ext>
            </a:extLst>
          </p:cNvPr>
          <p:cNvGraphicFramePr/>
          <p:nvPr/>
        </p:nvGraphicFramePr>
        <p:xfrm>
          <a:off x="801342" y="1862746"/>
          <a:ext cx="7325132" cy="108395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2" r:lo="rId13" r:qs="rId14" r:cs="rId15"/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B951D84D-5776-463A-01AD-FB91C577D77E}"/>
              </a:ext>
            </a:extLst>
          </p:cNvPr>
          <p:cNvSpPr txBox="1"/>
          <p:nvPr/>
        </p:nvSpPr>
        <p:spPr>
          <a:xfrm>
            <a:off x="5747657" y="6383363"/>
            <a:ext cx="6444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>
                    <a:lumMod val="6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AT epicardial adipose tissue; LVM left ventricular mass; LV left </a:t>
            </a:r>
            <a:r>
              <a:rPr kumimoji="0" lang="en-GB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>
                    <a:lumMod val="6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enticular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white">
                    <a:lumMod val="6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BMI body mass index; LDL low density lipoprotein; LVH left ventricular hypertrophy 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2F4CBAA0-B1DA-BB3D-5A60-0805A8D8EFF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110054" y="2482174"/>
            <a:ext cx="929045" cy="9290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424F20CB-AF7C-A96D-5EFA-A309AE4FC4EE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 l="10782" t="10327" r="9606" b="8128"/>
          <a:stretch>
            <a:fillRect/>
          </a:stretch>
        </p:blipFill>
        <p:spPr>
          <a:xfrm>
            <a:off x="7754284" y="2464756"/>
            <a:ext cx="1051905" cy="1574418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32334C7F-51C8-5CD2-BA31-9EEB3F150B7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673920" y="4235115"/>
            <a:ext cx="1390797" cy="1766447"/>
          </a:xfrm>
          <a:prstGeom prst="rect">
            <a:avLst/>
          </a:prstGeom>
        </p:spPr>
      </p:pic>
      <p:graphicFrame>
        <p:nvGraphicFramePr>
          <p:cNvPr id="12" name="Diagramm 11">
            <a:extLst>
              <a:ext uri="{FF2B5EF4-FFF2-40B4-BE49-F238E27FC236}">
                <a16:creationId xmlns:a16="http://schemas.microsoft.com/office/drawing/2014/main" id="{51033D97-32E4-9ED2-0EBE-589FA956BE1E}"/>
              </a:ext>
            </a:extLst>
          </p:cNvPr>
          <p:cNvGraphicFramePr/>
          <p:nvPr/>
        </p:nvGraphicFramePr>
        <p:xfrm>
          <a:off x="319906" y="483258"/>
          <a:ext cx="4976109" cy="6036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0" r:lo="rId21" r:qs="rId22" r:cs="rId23"/>
          </a:graphicData>
        </a:graphic>
      </p:graphicFrame>
      <p:sp>
        <p:nvSpPr>
          <p:cNvPr id="13" name="Textfeld 12">
            <a:extLst>
              <a:ext uri="{FF2B5EF4-FFF2-40B4-BE49-F238E27FC236}">
                <a16:creationId xmlns:a16="http://schemas.microsoft.com/office/drawing/2014/main" id="{41CB6FD4-B315-42DE-5DB1-FC2D3CD3C29F}"/>
              </a:ext>
            </a:extLst>
          </p:cNvPr>
          <p:cNvSpPr txBox="1"/>
          <p:nvPr/>
        </p:nvSpPr>
        <p:spPr>
          <a:xfrm>
            <a:off x="2367534" y="223686"/>
            <a:ext cx="1100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adults</a:t>
            </a:r>
          </a:p>
        </p:txBody>
      </p:sp>
      <p:graphicFrame>
        <p:nvGraphicFramePr>
          <p:cNvPr id="14" name="Diagramm 13">
            <a:extLst>
              <a:ext uri="{FF2B5EF4-FFF2-40B4-BE49-F238E27FC236}">
                <a16:creationId xmlns:a16="http://schemas.microsoft.com/office/drawing/2014/main" id="{8EFE0652-4845-E47A-F25A-621F832475BB}"/>
              </a:ext>
            </a:extLst>
          </p:cNvPr>
          <p:cNvGraphicFramePr/>
          <p:nvPr/>
        </p:nvGraphicFramePr>
        <p:xfrm>
          <a:off x="6868149" y="483258"/>
          <a:ext cx="4976109" cy="6036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5" r:lo="rId26" r:qs="rId27" r:cs="rId28"/>
          </a:graphicData>
        </a:graphic>
      </p:graphicFrame>
      <p:sp>
        <p:nvSpPr>
          <p:cNvPr id="15" name="Textfeld 14">
            <a:extLst>
              <a:ext uri="{FF2B5EF4-FFF2-40B4-BE49-F238E27FC236}">
                <a16:creationId xmlns:a16="http://schemas.microsoft.com/office/drawing/2014/main" id="{7C0AFA79-1233-A942-97D3-59131573D671}"/>
              </a:ext>
            </a:extLst>
          </p:cNvPr>
          <p:cNvSpPr txBox="1"/>
          <p:nvPr/>
        </p:nvSpPr>
        <p:spPr>
          <a:xfrm>
            <a:off x="8923067" y="223686"/>
            <a:ext cx="1100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adults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B5D6DB44-0DD6-A476-8FF0-0A00E54218BB}"/>
              </a:ext>
            </a:extLst>
          </p:cNvPr>
          <p:cNvSpPr txBox="1"/>
          <p:nvPr/>
        </p:nvSpPr>
        <p:spPr>
          <a:xfrm>
            <a:off x="8410401" y="1057851"/>
            <a:ext cx="18916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  <a:r>
              <a:rPr kumimoji="0" lang="en-GB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d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xperimental data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C6647A4D-D343-3BAD-626E-D5D9D7F7EC29}"/>
              </a:ext>
            </a:extLst>
          </p:cNvPr>
          <p:cNvCxnSpPr>
            <a:cxnSpLocks/>
          </p:cNvCxnSpPr>
          <p:nvPr/>
        </p:nvCxnSpPr>
        <p:spPr>
          <a:xfrm>
            <a:off x="240632" y="1388789"/>
            <a:ext cx="1176225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feld 21">
            <a:extLst>
              <a:ext uri="{FF2B5EF4-FFF2-40B4-BE49-F238E27FC236}">
                <a16:creationId xmlns:a16="http://schemas.microsoft.com/office/drawing/2014/main" id="{E8C0C02C-C987-E789-C234-4FDDD8763E70}"/>
              </a:ext>
            </a:extLst>
          </p:cNvPr>
          <p:cNvSpPr txBox="1"/>
          <p:nvPr/>
        </p:nvSpPr>
        <p:spPr>
          <a:xfrm>
            <a:off x="4558297" y="1204849"/>
            <a:ext cx="281878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mited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ta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or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lderly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E9A4BD24-3788-665D-7EB3-7A8128EBCFDB}"/>
              </a:ext>
            </a:extLst>
          </p:cNvPr>
          <p:cNvSpPr txBox="1"/>
          <p:nvPr/>
        </p:nvSpPr>
        <p:spPr>
          <a:xfrm>
            <a:off x="130629" y="91069"/>
            <a:ext cx="1570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ackground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B3598D8-137F-50C9-5F7A-A1E55BD78C3E}"/>
              </a:ext>
            </a:extLst>
          </p:cNvPr>
          <p:cNvSpPr txBox="1"/>
          <p:nvPr/>
        </p:nvSpPr>
        <p:spPr>
          <a:xfrm>
            <a:off x="130629" y="1389515"/>
            <a:ext cx="23375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thods &amp;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ults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746D911D-E20E-B2F9-5BA8-28AF0C743A04}"/>
              </a:ext>
            </a:extLst>
          </p:cNvPr>
          <p:cNvSpPr txBox="1"/>
          <p:nvPr/>
        </p:nvSpPr>
        <p:spPr>
          <a:xfrm>
            <a:off x="7541155" y="5661649"/>
            <a:ext cx="1815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R=1.36 per mm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03388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Breitbild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xander Schober</dc:creator>
  <cp:lastModifiedBy>Alexander Schober</cp:lastModifiedBy>
  <cp:revision>10</cp:revision>
  <dcterms:created xsi:type="dcterms:W3CDTF">2025-08-08T17:35:49Z</dcterms:created>
  <dcterms:modified xsi:type="dcterms:W3CDTF">2026-01-05T09:36:29Z</dcterms:modified>
</cp:coreProperties>
</file>